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62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28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3514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20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613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62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014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425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629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7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926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414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347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BCA1B9-6C3D-4FAC-AEBF-1DFD5B70A035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BE0F1-50CD-446E-8DCC-134A740EE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118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628650" y="1048893"/>
            <a:ext cx="7845425" cy="5736425"/>
            <a:chOff x="1104900" y="994575"/>
            <a:chExt cx="7845425" cy="5736425"/>
          </a:xfrm>
        </p:grpSpPr>
        <p:sp>
          <p:nvSpPr>
            <p:cNvPr id="4" name="Line 162"/>
            <p:cNvSpPr>
              <a:spLocks noChangeShapeType="1"/>
            </p:cNvSpPr>
            <p:nvPr/>
          </p:nvSpPr>
          <p:spPr bwMode="auto">
            <a:xfrm flipH="1" flipV="1">
              <a:off x="2137353" y="6067248"/>
              <a:ext cx="60761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" name="Rectangle 7"/>
            <p:cNvSpPr>
              <a:spLocks noChangeArrowheads="1"/>
            </p:cNvSpPr>
            <p:nvPr/>
          </p:nvSpPr>
          <p:spPr bwMode="auto">
            <a:xfrm>
              <a:off x="2198688" y="1166813"/>
              <a:ext cx="6646862" cy="489902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Line 12"/>
            <p:cNvSpPr>
              <a:spLocks noChangeShapeType="1"/>
            </p:cNvSpPr>
            <p:nvPr/>
          </p:nvSpPr>
          <p:spPr bwMode="auto">
            <a:xfrm>
              <a:off x="2198688" y="6065838"/>
              <a:ext cx="664686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" name="Line 16"/>
            <p:cNvSpPr>
              <a:spLocks noChangeShapeType="1"/>
            </p:cNvSpPr>
            <p:nvPr/>
          </p:nvSpPr>
          <p:spPr bwMode="auto">
            <a:xfrm>
              <a:off x="305911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Line 20"/>
            <p:cNvSpPr>
              <a:spLocks noChangeShapeType="1"/>
            </p:cNvSpPr>
            <p:nvPr/>
          </p:nvSpPr>
          <p:spPr bwMode="auto">
            <a:xfrm>
              <a:off x="3951288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Line 24"/>
            <p:cNvSpPr>
              <a:spLocks noChangeShapeType="1"/>
            </p:cNvSpPr>
            <p:nvPr/>
          </p:nvSpPr>
          <p:spPr bwMode="auto">
            <a:xfrm>
              <a:off x="483711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Line 28"/>
            <p:cNvSpPr>
              <a:spLocks noChangeShapeType="1"/>
            </p:cNvSpPr>
            <p:nvPr/>
          </p:nvSpPr>
          <p:spPr bwMode="auto">
            <a:xfrm>
              <a:off x="5724525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Line 32"/>
            <p:cNvSpPr>
              <a:spLocks noChangeShapeType="1"/>
            </p:cNvSpPr>
            <p:nvPr/>
          </p:nvSpPr>
          <p:spPr bwMode="auto">
            <a:xfrm>
              <a:off x="6611938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Line 36"/>
            <p:cNvSpPr>
              <a:spLocks noChangeShapeType="1"/>
            </p:cNvSpPr>
            <p:nvPr/>
          </p:nvSpPr>
          <p:spPr bwMode="auto">
            <a:xfrm>
              <a:off x="7499350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Line 40"/>
            <p:cNvSpPr>
              <a:spLocks noChangeShapeType="1"/>
            </p:cNvSpPr>
            <p:nvPr/>
          </p:nvSpPr>
          <p:spPr bwMode="auto">
            <a:xfrm>
              <a:off x="838676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44"/>
            <p:cNvSpPr>
              <a:spLocks noChangeShapeType="1"/>
            </p:cNvSpPr>
            <p:nvPr/>
          </p:nvSpPr>
          <p:spPr bwMode="auto">
            <a:xfrm>
              <a:off x="305911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Line 46"/>
            <p:cNvSpPr>
              <a:spLocks noChangeShapeType="1"/>
            </p:cNvSpPr>
            <p:nvPr/>
          </p:nvSpPr>
          <p:spPr bwMode="auto">
            <a:xfrm>
              <a:off x="3951288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48"/>
            <p:cNvSpPr>
              <a:spLocks noChangeShapeType="1"/>
            </p:cNvSpPr>
            <p:nvPr/>
          </p:nvSpPr>
          <p:spPr bwMode="auto">
            <a:xfrm>
              <a:off x="483711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Line 50"/>
            <p:cNvSpPr>
              <a:spLocks noChangeShapeType="1"/>
            </p:cNvSpPr>
            <p:nvPr/>
          </p:nvSpPr>
          <p:spPr bwMode="auto">
            <a:xfrm>
              <a:off x="5724525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52"/>
            <p:cNvSpPr>
              <a:spLocks noChangeShapeType="1"/>
            </p:cNvSpPr>
            <p:nvPr/>
          </p:nvSpPr>
          <p:spPr bwMode="auto">
            <a:xfrm>
              <a:off x="6611938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Line 54"/>
            <p:cNvSpPr>
              <a:spLocks noChangeShapeType="1"/>
            </p:cNvSpPr>
            <p:nvPr/>
          </p:nvSpPr>
          <p:spPr bwMode="auto">
            <a:xfrm>
              <a:off x="7499350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Line 56"/>
            <p:cNvSpPr>
              <a:spLocks noChangeShapeType="1"/>
            </p:cNvSpPr>
            <p:nvPr/>
          </p:nvSpPr>
          <p:spPr bwMode="auto">
            <a:xfrm>
              <a:off x="8386763" y="6065837"/>
              <a:ext cx="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59"/>
            <p:cNvSpPr>
              <a:spLocks noChangeArrowheads="1"/>
            </p:cNvSpPr>
            <p:nvPr/>
          </p:nvSpPr>
          <p:spPr bwMode="auto">
            <a:xfrm>
              <a:off x="3006725" y="614362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61"/>
            <p:cNvSpPr>
              <a:spLocks noChangeArrowheads="1"/>
            </p:cNvSpPr>
            <p:nvPr/>
          </p:nvSpPr>
          <p:spPr bwMode="auto">
            <a:xfrm>
              <a:off x="3898900" y="614362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63"/>
            <p:cNvSpPr>
              <a:spLocks noChangeArrowheads="1"/>
            </p:cNvSpPr>
            <p:nvPr/>
          </p:nvSpPr>
          <p:spPr bwMode="auto">
            <a:xfrm>
              <a:off x="4784725" y="614362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65"/>
            <p:cNvSpPr>
              <a:spLocks noChangeArrowheads="1"/>
            </p:cNvSpPr>
            <p:nvPr/>
          </p:nvSpPr>
          <p:spPr bwMode="auto">
            <a:xfrm>
              <a:off x="5672138" y="6143625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67"/>
            <p:cNvSpPr>
              <a:spLocks noChangeArrowheads="1"/>
            </p:cNvSpPr>
            <p:nvPr/>
          </p:nvSpPr>
          <p:spPr bwMode="auto">
            <a:xfrm>
              <a:off x="6529388" y="614362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69"/>
            <p:cNvSpPr>
              <a:spLocks noChangeArrowheads="1"/>
            </p:cNvSpPr>
            <p:nvPr/>
          </p:nvSpPr>
          <p:spPr bwMode="auto">
            <a:xfrm>
              <a:off x="7416800" y="614362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71"/>
            <p:cNvSpPr>
              <a:spLocks noChangeArrowheads="1"/>
            </p:cNvSpPr>
            <p:nvPr/>
          </p:nvSpPr>
          <p:spPr bwMode="auto">
            <a:xfrm>
              <a:off x="8304213" y="614362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73"/>
            <p:cNvSpPr>
              <a:spLocks noChangeArrowheads="1"/>
            </p:cNvSpPr>
            <p:nvPr/>
          </p:nvSpPr>
          <p:spPr bwMode="auto">
            <a:xfrm>
              <a:off x="4678356" y="6437313"/>
              <a:ext cx="126951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 (minutes)</a:t>
              </a:r>
              <a:endPara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Line 74"/>
            <p:cNvSpPr>
              <a:spLocks noChangeShapeType="1"/>
            </p:cNvSpPr>
            <p:nvPr/>
          </p:nvSpPr>
          <p:spPr bwMode="auto">
            <a:xfrm flipH="1" flipV="1">
              <a:off x="2198524" y="1089420"/>
              <a:ext cx="0" cy="4976417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Line 75"/>
            <p:cNvSpPr>
              <a:spLocks noChangeShapeType="1"/>
            </p:cNvSpPr>
            <p:nvPr/>
          </p:nvSpPr>
          <p:spPr bwMode="auto">
            <a:xfrm flipH="1">
              <a:off x="2185988" y="6065838"/>
              <a:ext cx="12700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Line 95"/>
            <p:cNvSpPr>
              <a:spLocks noChangeShapeType="1"/>
            </p:cNvSpPr>
            <p:nvPr/>
          </p:nvSpPr>
          <p:spPr bwMode="auto">
            <a:xfrm flipH="1">
              <a:off x="2185988" y="4819650"/>
              <a:ext cx="12700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2" name="Line 115"/>
            <p:cNvSpPr>
              <a:spLocks noChangeShapeType="1"/>
            </p:cNvSpPr>
            <p:nvPr/>
          </p:nvSpPr>
          <p:spPr bwMode="auto">
            <a:xfrm flipH="1">
              <a:off x="2185988" y="3578225"/>
              <a:ext cx="12700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Line 135"/>
            <p:cNvSpPr>
              <a:spLocks noChangeShapeType="1"/>
            </p:cNvSpPr>
            <p:nvPr/>
          </p:nvSpPr>
          <p:spPr bwMode="auto">
            <a:xfrm flipH="1">
              <a:off x="2185988" y="2333625"/>
              <a:ext cx="12700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Line 154"/>
            <p:cNvSpPr>
              <a:spLocks noChangeShapeType="1"/>
            </p:cNvSpPr>
            <p:nvPr/>
          </p:nvSpPr>
          <p:spPr bwMode="auto">
            <a:xfrm flipH="1">
              <a:off x="2171700" y="6065838"/>
              <a:ext cx="26987" cy="360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Line 158"/>
            <p:cNvSpPr>
              <a:spLocks noChangeShapeType="1"/>
            </p:cNvSpPr>
            <p:nvPr/>
          </p:nvSpPr>
          <p:spPr bwMode="auto">
            <a:xfrm flipH="1">
              <a:off x="2171700" y="4819650"/>
              <a:ext cx="26987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Line 162"/>
            <p:cNvSpPr>
              <a:spLocks noChangeShapeType="1"/>
            </p:cNvSpPr>
            <p:nvPr/>
          </p:nvSpPr>
          <p:spPr bwMode="auto">
            <a:xfrm flipH="1" flipV="1">
              <a:off x="2137925" y="3577831"/>
              <a:ext cx="60761" cy="394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Line 166"/>
            <p:cNvSpPr>
              <a:spLocks noChangeShapeType="1"/>
            </p:cNvSpPr>
            <p:nvPr/>
          </p:nvSpPr>
          <p:spPr bwMode="auto">
            <a:xfrm flipH="1">
              <a:off x="2171700" y="2333625"/>
              <a:ext cx="26987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Rectangle 170"/>
            <p:cNvSpPr>
              <a:spLocks noChangeArrowheads="1"/>
            </p:cNvSpPr>
            <p:nvPr/>
          </p:nvSpPr>
          <p:spPr bwMode="auto">
            <a:xfrm>
              <a:off x="1846660" y="5948363"/>
              <a:ext cx="24846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174"/>
            <p:cNvSpPr>
              <a:spLocks noChangeArrowheads="1"/>
            </p:cNvSpPr>
            <p:nvPr/>
          </p:nvSpPr>
          <p:spPr bwMode="auto">
            <a:xfrm>
              <a:off x="1647888" y="4704557"/>
              <a:ext cx="447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0e5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178"/>
            <p:cNvSpPr>
              <a:spLocks noChangeArrowheads="1"/>
            </p:cNvSpPr>
            <p:nvPr/>
          </p:nvSpPr>
          <p:spPr bwMode="auto">
            <a:xfrm>
              <a:off x="1647888" y="3462338"/>
              <a:ext cx="447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0e5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182"/>
            <p:cNvSpPr>
              <a:spLocks noChangeArrowheads="1"/>
            </p:cNvSpPr>
            <p:nvPr/>
          </p:nvSpPr>
          <p:spPr bwMode="auto">
            <a:xfrm>
              <a:off x="1647888" y="2220913"/>
              <a:ext cx="447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0e5</a:t>
              </a:r>
              <a:endParaRPr kumimoji="0" lang="en-US" altLang="en-US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186"/>
            <p:cNvSpPr>
              <a:spLocks noChangeArrowheads="1"/>
            </p:cNvSpPr>
            <p:nvPr/>
          </p:nvSpPr>
          <p:spPr bwMode="auto">
            <a:xfrm>
              <a:off x="1647888" y="994575"/>
              <a:ext cx="447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400" dirty="0">
                  <a:solidFill>
                    <a:srgbClr val="000000"/>
                  </a:solidFill>
                </a:rPr>
                <a:t>8</a:t>
              </a:r>
              <a:r>
                <a: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.0e5</a:t>
              </a:r>
              <a:endParaRPr kumimoji="0" lang="en-US" altLang="en-US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" name="Rectangle 187"/>
            <p:cNvSpPr>
              <a:spLocks noChangeArrowheads="1"/>
            </p:cNvSpPr>
            <p:nvPr/>
          </p:nvSpPr>
          <p:spPr bwMode="auto">
            <a:xfrm rot="16200000" flipH="1">
              <a:off x="312847" y="3510191"/>
              <a:ext cx="216245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Intensity (counts</a:t>
              </a:r>
              <a:r>
                <a:rPr lang="en-US" altLang="en-US" sz="1400" b="1" dirty="0">
                  <a:solidFill>
                    <a:srgbClr val="000000"/>
                  </a:solidFill>
                </a:rPr>
                <a:t>/</a:t>
              </a:r>
              <a:r>
                <a:rPr kumimoji="0" lang="en-US" altLang="en-US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econd)</a:t>
              </a:r>
              <a:endParaRPr kumimoji="0" lang="en-US" altLang="en-US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189"/>
            <p:cNvSpPr>
              <a:spLocks/>
            </p:cNvSpPr>
            <p:nvPr/>
          </p:nvSpPr>
          <p:spPr bwMode="auto">
            <a:xfrm>
              <a:off x="2198688" y="1166813"/>
              <a:ext cx="6642100" cy="4899025"/>
            </a:xfrm>
            <a:custGeom>
              <a:avLst/>
              <a:gdLst>
                <a:gd name="T0" fmla="*/ 9 w 1520"/>
                <a:gd name="T1" fmla="*/ 1121 h 1121"/>
                <a:gd name="T2" fmla="*/ 26 w 1520"/>
                <a:gd name="T3" fmla="*/ 1121 h 1121"/>
                <a:gd name="T4" fmla="*/ 43 w 1520"/>
                <a:gd name="T5" fmla="*/ 1121 h 1121"/>
                <a:gd name="T6" fmla="*/ 60 w 1520"/>
                <a:gd name="T7" fmla="*/ 1121 h 1121"/>
                <a:gd name="T8" fmla="*/ 77 w 1520"/>
                <a:gd name="T9" fmla="*/ 1121 h 1121"/>
                <a:gd name="T10" fmla="*/ 94 w 1520"/>
                <a:gd name="T11" fmla="*/ 1121 h 1121"/>
                <a:gd name="T12" fmla="*/ 111 w 1520"/>
                <a:gd name="T13" fmla="*/ 1121 h 1121"/>
                <a:gd name="T14" fmla="*/ 128 w 1520"/>
                <a:gd name="T15" fmla="*/ 1121 h 1121"/>
                <a:gd name="T16" fmla="*/ 145 w 1520"/>
                <a:gd name="T17" fmla="*/ 1121 h 1121"/>
                <a:gd name="T18" fmla="*/ 171 w 1520"/>
                <a:gd name="T19" fmla="*/ 1121 h 1121"/>
                <a:gd name="T20" fmla="*/ 197 w 1520"/>
                <a:gd name="T21" fmla="*/ 1121 h 1121"/>
                <a:gd name="T22" fmla="*/ 223 w 1520"/>
                <a:gd name="T23" fmla="*/ 1121 h 1121"/>
                <a:gd name="T24" fmla="*/ 250 w 1520"/>
                <a:gd name="T25" fmla="*/ 1121 h 1121"/>
                <a:gd name="T26" fmla="*/ 276 w 1520"/>
                <a:gd name="T27" fmla="*/ 1121 h 1121"/>
                <a:gd name="T28" fmla="*/ 302 w 1520"/>
                <a:gd name="T29" fmla="*/ 1121 h 1121"/>
                <a:gd name="T30" fmla="*/ 329 w 1520"/>
                <a:gd name="T31" fmla="*/ 1121 h 1121"/>
                <a:gd name="T32" fmla="*/ 355 w 1520"/>
                <a:gd name="T33" fmla="*/ 1121 h 1121"/>
                <a:gd name="T34" fmla="*/ 381 w 1520"/>
                <a:gd name="T35" fmla="*/ 1121 h 1121"/>
                <a:gd name="T36" fmla="*/ 408 w 1520"/>
                <a:gd name="T37" fmla="*/ 1121 h 1121"/>
                <a:gd name="T38" fmla="*/ 434 w 1520"/>
                <a:gd name="T39" fmla="*/ 1121 h 1121"/>
                <a:gd name="T40" fmla="*/ 460 w 1520"/>
                <a:gd name="T41" fmla="*/ 1121 h 1121"/>
                <a:gd name="T42" fmla="*/ 487 w 1520"/>
                <a:gd name="T43" fmla="*/ 1121 h 1121"/>
                <a:gd name="T44" fmla="*/ 513 w 1520"/>
                <a:gd name="T45" fmla="*/ 1121 h 1121"/>
                <a:gd name="T46" fmla="*/ 539 w 1520"/>
                <a:gd name="T47" fmla="*/ 1121 h 1121"/>
                <a:gd name="T48" fmla="*/ 566 w 1520"/>
                <a:gd name="T49" fmla="*/ 1121 h 1121"/>
                <a:gd name="T50" fmla="*/ 592 w 1520"/>
                <a:gd name="T51" fmla="*/ 1121 h 1121"/>
                <a:gd name="T52" fmla="*/ 618 w 1520"/>
                <a:gd name="T53" fmla="*/ 1121 h 1121"/>
                <a:gd name="T54" fmla="*/ 645 w 1520"/>
                <a:gd name="T55" fmla="*/ 1121 h 1121"/>
                <a:gd name="T56" fmla="*/ 671 w 1520"/>
                <a:gd name="T57" fmla="*/ 1121 h 1121"/>
                <a:gd name="T58" fmla="*/ 697 w 1520"/>
                <a:gd name="T59" fmla="*/ 1121 h 1121"/>
                <a:gd name="T60" fmla="*/ 724 w 1520"/>
                <a:gd name="T61" fmla="*/ 1121 h 1121"/>
                <a:gd name="T62" fmla="*/ 750 w 1520"/>
                <a:gd name="T63" fmla="*/ 1121 h 1121"/>
                <a:gd name="T64" fmla="*/ 776 w 1520"/>
                <a:gd name="T65" fmla="*/ 1121 h 1121"/>
                <a:gd name="T66" fmla="*/ 802 w 1520"/>
                <a:gd name="T67" fmla="*/ 1121 h 1121"/>
                <a:gd name="T68" fmla="*/ 829 w 1520"/>
                <a:gd name="T69" fmla="*/ 1121 h 1121"/>
                <a:gd name="T70" fmla="*/ 855 w 1520"/>
                <a:gd name="T71" fmla="*/ 1121 h 1121"/>
                <a:gd name="T72" fmla="*/ 881 w 1520"/>
                <a:gd name="T73" fmla="*/ 1121 h 1121"/>
                <a:gd name="T74" fmla="*/ 908 w 1520"/>
                <a:gd name="T75" fmla="*/ 1121 h 1121"/>
                <a:gd name="T76" fmla="*/ 934 w 1520"/>
                <a:gd name="T77" fmla="*/ 1121 h 1121"/>
                <a:gd name="T78" fmla="*/ 960 w 1520"/>
                <a:gd name="T79" fmla="*/ 1121 h 1121"/>
                <a:gd name="T80" fmla="*/ 987 w 1520"/>
                <a:gd name="T81" fmla="*/ 1121 h 1121"/>
                <a:gd name="T82" fmla="*/ 1013 w 1520"/>
                <a:gd name="T83" fmla="*/ 1121 h 1121"/>
                <a:gd name="T84" fmla="*/ 1039 w 1520"/>
                <a:gd name="T85" fmla="*/ 1121 h 1121"/>
                <a:gd name="T86" fmla="*/ 1066 w 1520"/>
                <a:gd name="T87" fmla="*/ 1121 h 1121"/>
                <a:gd name="T88" fmla="*/ 1092 w 1520"/>
                <a:gd name="T89" fmla="*/ 1121 h 1121"/>
                <a:gd name="T90" fmla="*/ 1118 w 1520"/>
                <a:gd name="T91" fmla="*/ 1121 h 1121"/>
                <a:gd name="T92" fmla="*/ 1145 w 1520"/>
                <a:gd name="T93" fmla="*/ 1121 h 1121"/>
                <a:gd name="T94" fmla="*/ 1171 w 1520"/>
                <a:gd name="T95" fmla="*/ 1121 h 1121"/>
                <a:gd name="T96" fmla="*/ 1197 w 1520"/>
                <a:gd name="T97" fmla="*/ 1119 h 1121"/>
                <a:gd name="T98" fmla="*/ 1224 w 1520"/>
                <a:gd name="T99" fmla="*/ 144 h 1121"/>
                <a:gd name="T100" fmla="*/ 1250 w 1520"/>
                <a:gd name="T101" fmla="*/ 1110 h 1121"/>
                <a:gd name="T102" fmla="*/ 1276 w 1520"/>
                <a:gd name="T103" fmla="*/ 1119 h 1121"/>
                <a:gd name="T104" fmla="*/ 1303 w 1520"/>
                <a:gd name="T105" fmla="*/ 1119 h 1121"/>
                <a:gd name="T106" fmla="*/ 1329 w 1520"/>
                <a:gd name="T107" fmla="*/ 1121 h 1121"/>
                <a:gd name="T108" fmla="*/ 1355 w 1520"/>
                <a:gd name="T109" fmla="*/ 1117 h 1121"/>
                <a:gd name="T110" fmla="*/ 1382 w 1520"/>
                <a:gd name="T111" fmla="*/ 1121 h 1121"/>
                <a:gd name="T112" fmla="*/ 1408 w 1520"/>
                <a:gd name="T113" fmla="*/ 1121 h 1121"/>
                <a:gd name="T114" fmla="*/ 1434 w 1520"/>
                <a:gd name="T115" fmla="*/ 1121 h 1121"/>
                <a:gd name="T116" fmla="*/ 1461 w 1520"/>
                <a:gd name="T117" fmla="*/ 1121 h 1121"/>
                <a:gd name="T118" fmla="*/ 1487 w 1520"/>
                <a:gd name="T119" fmla="*/ 1121 h 1121"/>
                <a:gd name="T120" fmla="*/ 1513 w 1520"/>
                <a:gd name="T121" fmla="*/ 1121 h 1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1520" h="1121">
                  <a:moveTo>
                    <a:pt x="0" y="1121"/>
                  </a:moveTo>
                  <a:lnTo>
                    <a:pt x="0" y="1121"/>
                  </a:lnTo>
                  <a:lnTo>
                    <a:pt x="4" y="1121"/>
                  </a:lnTo>
                  <a:lnTo>
                    <a:pt x="9" y="1121"/>
                  </a:lnTo>
                  <a:lnTo>
                    <a:pt x="13" y="1121"/>
                  </a:lnTo>
                  <a:lnTo>
                    <a:pt x="17" y="1121"/>
                  </a:lnTo>
                  <a:lnTo>
                    <a:pt x="21" y="1121"/>
                  </a:lnTo>
                  <a:lnTo>
                    <a:pt x="26" y="1121"/>
                  </a:lnTo>
                  <a:lnTo>
                    <a:pt x="30" y="1121"/>
                  </a:lnTo>
                  <a:lnTo>
                    <a:pt x="34" y="1121"/>
                  </a:lnTo>
                  <a:lnTo>
                    <a:pt x="38" y="1121"/>
                  </a:lnTo>
                  <a:lnTo>
                    <a:pt x="43" y="1121"/>
                  </a:lnTo>
                  <a:lnTo>
                    <a:pt x="47" y="1121"/>
                  </a:lnTo>
                  <a:lnTo>
                    <a:pt x="51" y="1121"/>
                  </a:lnTo>
                  <a:lnTo>
                    <a:pt x="55" y="1121"/>
                  </a:lnTo>
                  <a:lnTo>
                    <a:pt x="60" y="1121"/>
                  </a:lnTo>
                  <a:lnTo>
                    <a:pt x="64" y="1121"/>
                  </a:lnTo>
                  <a:lnTo>
                    <a:pt x="68" y="1121"/>
                  </a:lnTo>
                  <a:lnTo>
                    <a:pt x="72" y="1121"/>
                  </a:lnTo>
                  <a:lnTo>
                    <a:pt x="77" y="1121"/>
                  </a:lnTo>
                  <a:lnTo>
                    <a:pt x="81" y="1121"/>
                  </a:lnTo>
                  <a:lnTo>
                    <a:pt x="85" y="1121"/>
                  </a:lnTo>
                  <a:lnTo>
                    <a:pt x="89" y="1121"/>
                  </a:lnTo>
                  <a:lnTo>
                    <a:pt x="94" y="1121"/>
                  </a:lnTo>
                  <a:lnTo>
                    <a:pt x="98" y="1121"/>
                  </a:lnTo>
                  <a:lnTo>
                    <a:pt x="102" y="1121"/>
                  </a:lnTo>
                  <a:lnTo>
                    <a:pt x="106" y="1121"/>
                  </a:lnTo>
                  <a:lnTo>
                    <a:pt x="111" y="1121"/>
                  </a:lnTo>
                  <a:lnTo>
                    <a:pt x="115" y="1121"/>
                  </a:lnTo>
                  <a:lnTo>
                    <a:pt x="119" y="1121"/>
                  </a:lnTo>
                  <a:lnTo>
                    <a:pt x="123" y="1121"/>
                  </a:lnTo>
                  <a:lnTo>
                    <a:pt x="128" y="1121"/>
                  </a:lnTo>
                  <a:lnTo>
                    <a:pt x="132" y="1121"/>
                  </a:lnTo>
                  <a:lnTo>
                    <a:pt x="136" y="1121"/>
                  </a:lnTo>
                  <a:lnTo>
                    <a:pt x="140" y="1121"/>
                  </a:lnTo>
                  <a:lnTo>
                    <a:pt x="145" y="1121"/>
                  </a:lnTo>
                  <a:lnTo>
                    <a:pt x="151" y="1121"/>
                  </a:lnTo>
                  <a:lnTo>
                    <a:pt x="158" y="1121"/>
                  </a:lnTo>
                  <a:lnTo>
                    <a:pt x="164" y="1121"/>
                  </a:lnTo>
                  <a:lnTo>
                    <a:pt x="171" y="1121"/>
                  </a:lnTo>
                  <a:lnTo>
                    <a:pt x="177" y="1121"/>
                  </a:lnTo>
                  <a:lnTo>
                    <a:pt x="184" y="1121"/>
                  </a:lnTo>
                  <a:lnTo>
                    <a:pt x="191" y="1121"/>
                  </a:lnTo>
                  <a:lnTo>
                    <a:pt x="197" y="1121"/>
                  </a:lnTo>
                  <a:lnTo>
                    <a:pt x="204" y="1121"/>
                  </a:lnTo>
                  <a:lnTo>
                    <a:pt x="210" y="1121"/>
                  </a:lnTo>
                  <a:lnTo>
                    <a:pt x="217" y="1121"/>
                  </a:lnTo>
                  <a:lnTo>
                    <a:pt x="223" y="1121"/>
                  </a:lnTo>
                  <a:lnTo>
                    <a:pt x="230" y="1121"/>
                  </a:lnTo>
                  <a:lnTo>
                    <a:pt x="237" y="1121"/>
                  </a:lnTo>
                  <a:lnTo>
                    <a:pt x="243" y="1121"/>
                  </a:lnTo>
                  <a:lnTo>
                    <a:pt x="250" y="1121"/>
                  </a:lnTo>
                  <a:lnTo>
                    <a:pt x="256" y="1121"/>
                  </a:lnTo>
                  <a:lnTo>
                    <a:pt x="263" y="1121"/>
                  </a:lnTo>
                  <a:lnTo>
                    <a:pt x="270" y="1121"/>
                  </a:lnTo>
                  <a:lnTo>
                    <a:pt x="276" y="1121"/>
                  </a:lnTo>
                  <a:lnTo>
                    <a:pt x="283" y="1121"/>
                  </a:lnTo>
                  <a:lnTo>
                    <a:pt x="289" y="1121"/>
                  </a:lnTo>
                  <a:lnTo>
                    <a:pt x="296" y="1121"/>
                  </a:lnTo>
                  <a:lnTo>
                    <a:pt x="302" y="1121"/>
                  </a:lnTo>
                  <a:lnTo>
                    <a:pt x="309" y="1121"/>
                  </a:lnTo>
                  <a:lnTo>
                    <a:pt x="316" y="1121"/>
                  </a:lnTo>
                  <a:lnTo>
                    <a:pt x="322" y="1121"/>
                  </a:lnTo>
                  <a:lnTo>
                    <a:pt x="329" y="1121"/>
                  </a:lnTo>
                  <a:lnTo>
                    <a:pt x="335" y="1121"/>
                  </a:lnTo>
                  <a:lnTo>
                    <a:pt x="342" y="1121"/>
                  </a:lnTo>
                  <a:lnTo>
                    <a:pt x="348" y="1119"/>
                  </a:lnTo>
                  <a:lnTo>
                    <a:pt x="355" y="1121"/>
                  </a:lnTo>
                  <a:lnTo>
                    <a:pt x="362" y="1121"/>
                  </a:lnTo>
                  <a:lnTo>
                    <a:pt x="368" y="1121"/>
                  </a:lnTo>
                  <a:lnTo>
                    <a:pt x="375" y="1121"/>
                  </a:lnTo>
                  <a:lnTo>
                    <a:pt x="381" y="1121"/>
                  </a:lnTo>
                  <a:lnTo>
                    <a:pt x="388" y="1121"/>
                  </a:lnTo>
                  <a:lnTo>
                    <a:pt x="395" y="1121"/>
                  </a:lnTo>
                  <a:lnTo>
                    <a:pt x="401" y="1121"/>
                  </a:lnTo>
                  <a:lnTo>
                    <a:pt x="408" y="1121"/>
                  </a:lnTo>
                  <a:lnTo>
                    <a:pt x="414" y="1121"/>
                  </a:lnTo>
                  <a:lnTo>
                    <a:pt x="421" y="1121"/>
                  </a:lnTo>
                  <a:lnTo>
                    <a:pt x="427" y="1121"/>
                  </a:lnTo>
                  <a:lnTo>
                    <a:pt x="434" y="1121"/>
                  </a:lnTo>
                  <a:lnTo>
                    <a:pt x="441" y="1121"/>
                  </a:lnTo>
                  <a:lnTo>
                    <a:pt x="447" y="1121"/>
                  </a:lnTo>
                  <a:lnTo>
                    <a:pt x="454" y="1121"/>
                  </a:lnTo>
                  <a:lnTo>
                    <a:pt x="460" y="1121"/>
                  </a:lnTo>
                  <a:lnTo>
                    <a:pt x="467" y="1121"/>
                  </a:lnTo>
                  <a:lnTo>
                    <a:pt x="474" y="1121"/>
                  </a:lnTo>
                  <a:lnTo>
                    <a:pt x="480" y="1121"/>
                  </a:lnTo>
                  <a:lnTo>
                    <a:pt x="487" y="1121"/>
                  </a:lnTo>
                  <a:lnTo>
                    <a:pt x="493" y="1121"/>
                  </a:lnTo>
                  <a:lnTo>
                    <a:pt x="500" y="1121"/>
                  </a:lnTo>
                  <a:lnTo>
                    <a:pt x="506" y="1121"/>
                  </a:lnTo>
                  <a:lnTo>
                    <a:pt x="513" y="1121"/>
                  </a:lnTo>
                  <a:lnTo>
                    <a:pt x="520" y="1121"/>
                  </a:lnTo>
                  <a:lnTo>
                    <a:pt x="526" y="1121"/>
                  </a:lnTo>
                  <a:lnTo>
                    <a:pt x="533" y="1121"/>
                  </a:lnTo>
                  <a:lnTo>
                    <a:pt x="539" y="1121"/>
                  </a:lnTo>
                  <a:lnTo>
                    <a:pt x="546" y="1121"/>
                  </a:lnTo>
                  <a:lnTo>
                    <a:pt x="552" y="1121"/>
                  </a:lnTo>
                  <a:lnTo>
                    <a:pt x="559" y="1121"/>
                  </a:lnTo>
                  <a:lnTo>
                    <a:pt x="566" y="1121"/>
                  </a:lnTo>
                  <a:lnTo>
                    <a:pt x="572" y="1121"/>
                  </a:lnTo>
                  <a:lnTo>
                    <a:pt x="579" y="1121"/>
                  </a:lnTo>
                  <a:lnTo>
                    <a:pt x="585" y="1121"/>
                  </a:lnTo>
                  <a:lnTo>
                    <a:pt x="592" y="1121"/>
                  </a:lnTo>
                  <a:lnTo>
                    <a:pt x="599" y="1121"/>
                  </a:lnTo>
                  <a:lnTo>
                    <a:pt x="605" y="1121"/>
                  </a:lnTo>
                  <a:lnTo>
                    <a:pt x="612" y="1121"/>
                  </a:lnTo>
                  <a:lnTo>
                    <a:pt x="618" y="1121"/>
                  </a:lnTo>
                  <a:lnTo>
                    <a:pt x="625" y="1121"/>
                  </a:lnTo>
                  <a:lnTo>
                    <a:pt x="631" y="1121"/>
                  </a:lnTo>
                  <a:lnTo>
                    <a:pt x="638" y="1121"/>
                  </a:lnTo>
                  <a:lnTo>
                    <a:pt x="645" y="1121"/>
                  </a:lnTo>
                  <a:lnTo>
                    <a:pt x="651" y="1121"/>
                  </a:lnTo>
                  <a:lnTo>
                    <a:pt x="658" y="1121"/>
                  </a:lnTo>
                  <a:lnTo>
                    <a:pt x="664" y="1121"/>
                  </a:lnTo>
                  <a:lnTo>
                    <a:pt x="671" y="1121"/>
                  </a:lnTo>
                  <a:lnTo>
                    <a:pt x="677" y="1121"/>
                  </a:lnTo>
                  <a:lnTo>
                    <a:pt x="684" y="1121"/>
                  </a:lnTo>
                  <a:lnTo>
                    <a:pt x="691" y="1121"/>
                  </a:lnTo>
                  <a:lnTo>
                    <a:pt x="697" y="1121"/>
                  </a:lnTo>
                  <a:lnTo>
                    <a:pt x="704" y="1121"/>
                  </a:lnTo>
                  <a:lnTo>
                    <a:pt x="710" y="1121"/>
                  </a:lnTo>
                  <a:lnTo>
                    <a:pt x="717" y="1121"/>
                  </a:lnTo>
                  <a:lnTo>
                    <a:pt x="724" y="1121"/>
                  </a:lnTo>
                  <a:lnTo>
                    <a:pt x="730" y="1121"/>
                  </a:lnTo>
                  <a:lnTo>
                    <a:pt x="737" y="1121"/>
                  </a:lnTo>
                  <a:lnTo>
                    <a:pt x="743" y="1121"/>
                  </a:lnTo>
                  <a:lnTo>
                    <a:pt x="750" y="1121"/>
                  </a:lnTo>
                  <a:lnTo>
                    <a:pt x="756" y="1121"/>
                  </a:lnTo>
                  <a:lnTo>
                    <a:pt x="763" y="1121"/>
                  </a:lnTo>
                  <a:lnTo>
                    <a:pt x="770" y="1121"/>
                  </a:lnTo>
                  <a:lnTo>
                    <a:pt x="776" y="1121"/>
                  </a:lnTo>
                  <a:lnTo>
                    <a:pt x="783" y="1121"/>
                  </a:lnTo>
                  <a:lnTo>
                    <a:pt x="789" y="1121"/>
                  </a:lnTo>
                  <a:lnTo>
                    <a:pt x="796" y="1121"/>
                  </a:lnTo>
                  <a:lnTo>
                    <a:pt x="802" y="1121"/>
                  </a:lnTo>
                  <a:lnTo>
                    <a:pt x="809" y="1121"/>
                  </a:lnTo>
                  <a:lnTo>
                    <a:pt x="816" y="1121"/>
                  </a:lnTo>
                  <a:lnTo>
                    <a:pt x="822" y="1121"/>
                  </a:lnTo>
                  <a:lnTo>
                    <a:pt x="829" y="1121"/>
                  </a:lnTo>
                  <a:lnTo>
                    <a:pt x="835" y="1121"/>
                  </a:lnTo>
                  <a:lnTo>
                    <a:pt x="842" y="1121"/>
                  </a:lnTo>
                  <a:lnTo>
                    <a:pt x="849" y="1121"/>
                  </a:lnTo>
                  <a:lnTo>
                    <a:pt x="855" y="1121"/>
                  </a:lnTo>
                  <a:lnTo>
                    <a:pt x="862" y="1121"/>
                  </a:lnTo>
                  <a:lnTo>
                    <a:pt x="868" y="1121"/>
                  </a:lnTo>
                  <a:lnTo>
                    <a:pt x="875" y="1121"/>
                  </a:lnTo>
                  <a:lnTo>
                    <a:pt x="881" y="1121"/>
                  </a:lnTo>
                  <a:lnTo>
                    <a:pt x="888" y="1121"/>
                  </a:lnTo>
                  <a:lnTo>
                    <a:pt x="895" y="1121"/>
                  </a:lnTo>
                  <a:lnTo>
                    <a:pt x="901" y="1121"/>
                  </a:lnTo>
                  <a:lnTo>
                    <a:pt x="908" y="1121"/>
                  </a:lnTo>
                  <a:lnTo>
                    <a:pt x="914" y="1121"/>
                  </a:lnTo>
                  <a:lnTo>
                    <a:pt x="921" y="1121"/>
                  </a:lnTo>
                  <a:lnTo>
                    <a:pt x="927" y="1121"/>
                  </a:lnTo>
                  <a:lnTo>
                    <a:pt x="934" y="1121"/>
                  </a:lnTo>
                  <a:lnTo>
                    <a:pt x="941" y="1121"/>
                  </a:lnTo>
                  <a:lnTo>
                    <a:pt x="947" y="1121"/>
                  </a:lnTo>
                  <a:lnTo>
                    <a:pt x="954" y="1121"/>
                  </a:lnTo>
                  <a:lnTo>
                    <a:pt x="960" y="1121"/>
                  </a:lnTo>
                  <a:lnTo>
                    <a:pt x="967" y="1121"/>
                  </a:lnTo>
                  <a:lnTo>
                    <a:pt x="974" y="1121"/>
                  </a:lnTo>
                  <a:lnTo>
                    <a:pt x="980" y="1121"/>
                  </a:lnTo>
                  <a:lnTo>
                    <a:pt x="987" y="1121"/>
                  </a:lnTo>
                  <a:lnTo>
                    <a:pt x="993" y="1121"/>
                  </a:lnTo>
                  <a:lnTo>
                    <a:pt x="1000" y="1121"/>
                  </a:lnTo>
                  <a:lnTo>
                    <a:pt x="1006" y="1121"/>
                  </a:lnTo>
                  <a:lnTo>
                    <a:pt x="1013" y="1121"/>
                  </a:lnTo>
                  <a:lnTo>
                    <a:pt x="1020" y="1121"/>
                  </a:lnTo>
                  <a:lnTo>
                    <a:pt x="1026" y="1121"/>
                  </a:lnTo>
                  <a:lnTo>
                    <a:pt x="1033" y="1121"/>
                  </a:lnTo>
                  <a:lnTo>
                    <a:pt x="1039" y="1121"/>
                  </a:lnTo>
                  <a:lnTo>
                    <a:pt x="1046" y="1121"/>
                  </a:lnTo>
                  <a:lnTo>
                    <a:pt x="1053" y="1121"/>
                  </a:lnTo>
                  <a:lnTo>
                    <a:pt x="1059" y="1121"/>
                  </a:lnTo>
                  <a:lnTo>
                    <a:pt x="1066" y="1121"/>
                  </a:lnTo>
                  <a:lnTo>
                    <a:pt x="1072" y="1121"/>
                  </a:lnTo>
                  <a:lnTo>
                    <a:pt x="1079" y="1121"/>
                  </a:lnTo>
                  <a:lnTo>
                    <a:pt x="1085" y="1121"/>
                  </a:lnTo>
                  <a:lnTo>
                    <a:pt x="1092" y="1121"/>
                  </a:lnTo>
                  <a:lnTo>
                    <a:pt x="1099" y="1121"/>
                  </a:lnTo>
                  <a:lnTo>
                    <a:pt x="1105" y="1119"/>
                  </a:lnTo>
                  <a:lnTo>
                    <a:pt x="1112" y="1121"/>
                  </a:lnTo>
                  <a:lnTo>
                    <a:pt x="1118" y="1121"/>
                  </a:lnTo>
                  <a:lnTo>
                    <a:pt x="1125" y="1121"/>
                  </a:lnTo>
                  <a:lnTo>
                    <a:pt x="1131" y="1121"/>
                  </a:lnTo>
                  <a:lnTo>
                    <a:pt x="1138" y="1121"/>
                  </a:lnTo>
                  <a:lnTo>
                    <a:pt x="1145" y="1121"/>
                  </a:lnTo>
                  <a:lnTo>
                    <a:pt x="1151" y="1121"/>
                  </a:lnTo>
                  <a:lnTo>
                    <a:pt x="1158" y="1121"/>
                  </a:lnTo>
                  <a:lnTo>
                    <a:pt x="1164" y="1119"/>
                  </a:lnTo>
                  <a:lnTo>
                    <a:pt x="1171" y="1121"/>
                  </a:lnTo>
                  <a:lnTo>
                    <a:pt x="1178" y="1121"/>
                  </a:lnTo>
                  <a:lnTo>
                    <a:pt x="1184" y="1121"/>
                  </a:lnTo>
                  <a:lnTo>
                    <a:pt x="1191" y="1121"/>
                  </a:lnTo>
                  <a:lnTo>
                    <a:pt x="1197" y="1119"/>
                  </a:lnTo>
                  <a:lnTo>
                    <a:pt x="1204" y="1039"/>
                  </a:lnTo>
                  <a:lnTo>
                    <a:pt x="1210" y="487"/>
                  </a:lnTo>
                  <a:lnTo>
                    <a:pt x="1217" y="0"/>
                  </a:lnTo>
                  <a:lnTo>
                    <a:pt x="1224" y="144"/>
                  </a:lnTo>
                  <a:lnTo>
                    <a:pt x="1230" y="607"/>
                  </a:lnTo>
                  <a:lnTo>
                    <a:pt x="1237" y="922"/>
                  </a:lnTo>
                  <a:lnTo>
                    <a:pt x="1243" y="1057"/>
                  </a:lnTo>
                  <a:lnTo>
                    <a:pt x="1250" y="1110"/>
                  </a:lnTo>
                  <a:lnTo>
                    <a:pt x="1257" y="1117"/>
                  </a:lnTo>
                  <a:lnTo>
                    <a:pt x="1263" y="1119"/>
                  </a:lnTo>
                  <a:lnTo>
                    <a:pt x="1270" y="1115"/>
                  </a:lnTo>
                  <a:lnTo>
                    <a:pt x="1276" y="1119"/>
                  </a:lnTo>
                  <a:lnTo>
                    <a:pt x="1283" y="1121"/>
                  </a:lnTo>
                  <a:lnTo>
                    <a:pt x="1289" y="1119"/>
                  </a:lnTo>
                  <a:lnTo>
                    <a:pt x="1296" y="1121"/>
                  </a:lnTo>
                  <a:lnTo>
                    <a:pt x="1303" y="1119"/>
                  </a:lnTo>
                  <a:lnTo>
                    <a:pt x="1309" y="1121"/>
                  </a:lnTo>
                  <a:lnTo>
                    <a:pt x="1316" y="1119"/>
                  </a:lnTo>
                  <a:lnTo>
                    <a:pt x="1322" y="1117"/>
                  </a:lnTo>
                  <a:lnTo>
                    <a:pt x="1329" y="1121"/>
                  </a:lnTo>
                  <a:lnTo>
                    <a:pt x="1336" y="1121"/>
                  </a:lnTo>
                  <a:lnTo>
                    <a:pt x="1342" y="1119"/>
                  </a:lnTo>
                  <a:lnTo>
                    <a:pt x="1349" y="1121"/>
                  </a:lnTo>
                  <a:lnTo>
                    <a:pt x="1355" y="1117"/>
                  </a:lnTo>
                  <a:lnTo>
                    <a:pt x="1362" y="1121"/>
                  </a:lnTo>
                  <a:lnTo>
                    <a:pt x="1368" y="1121"/>
                  </a:lnTo>
                  <a:lnTo>
                    <a:pt x="1375" y="1119"/>
                  </a:lnTo>
                  <a:lnTo>
                    <a:pt x="1382" y="1121"/>
                  </a:lnTo>
                  <a:lnTo>
                    <a:pt x="1388" y="1121"/>
                  </a:lnTo>
                  <a:lnTo>
                    <a:pt x="1395" y="1121"/>
                  </a:lnTo>
                  <a:lnTo>
                    <a:pt x="1401" y="1121"/>
                  </a:lnTo>
                  <a:lnTo>
                    <a:pt x="1408" y="1121"/>
                  </a:lnTo>
                  <a:lnTo>
                    <a:pt x="1414" y="1121"/>
                  </a:lnTo>
                  <a:lnTo>
                    <a:pt x="1421" y="1121"/>
                  </a:lnTo>
                  <a:lnTo>
                    <a:pt x="1428" y="1117"/>
                  </a:lnTo>
                  <a:lnTo>
                    <a:pt x="1434" y="1121"/>
                  </a:lnTo>
                  <a:lnTo>
                    <a:pt x="1441" y="1121"/>
                  </a:lnTo>
                  <a:lnTo>
                    <a:pt x="1447" y="1121"/>
                  </a:lnTo>
                  <a:lnTo>
                    <a:pt x="1454" y="1121"/>
                  </a:lnTo>
                  <a:lnTo>
                    <a:pt x="1461" y="1121"/>
                  </a:lnTo>
                  <a:lnTo>
                    <a:pt x="1467" y="1121"/>
                  </a:lnTo>
                  <a:lnTo>
                    <a:pt x="1474" y="1121"/>
                  </a:lnTo>
                  <a:lnTo>
                    <a:pt x="1480" y="1121"/>
                  </a:lnTo>
                  <a:lnTo>
                    <a:pt x="1487" y="1121"/>
                  </a:lnTo>
                  <a:lnTo>
                    <a:pt x="1493" y="1121"/>
                  </a:lnTo>
                  <a:lnTo>
                    <a:pt x="1500" y="1121"/>
                  </a:lnTo>
                  <a:lnTo>
                    <a:pt x="1507" y="1119"/>
                  </a:lnTo>
                  <a:lnTo>
                    <a:pt x="1513" y="1121"/>
                  </a:lnTo>
                  <a:lnTo>
                    <a:pt x="1520" y="1121"/>
                  </a:lnTo>
                </a:path>
              </a:pathLst>
            </a:custGeom>
            <a:noFill/>
            <a:ln w="190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190"/>
            <p:cNvSpPr>
              <a:spLocks/>
            </p:cNvSpPr>
            <p:nvPr/>
          </p:nvSpPr>
          <p:spPr bwMode="auto">
            <a:xfrm>
              <a:off x="2158373" y="6056542"/>
              <a:ext cx="6642100" cy="9525"/>
            </a:xfrm>
            <a:custGeom>
              <a:avLst/>
              <a:gdLst>
                <a:gd name="T0" fmla="*/ 9 w 1520"/>
                <a:gd name="T1" fmla="*/ 2 h 2"/>
                <a:gd name="T2" fmla="*/ 33 w 1520"/>
                <a:gd name="T3" fmla="*/ 2 h 2"/>
                <a:gd name="T4" fmla="*/ 59 w 1520"/>
                <a:gd name="T5" fmla="*/ 2 h 2"/>
                <a:gd name="T6" fmla="*/ 85 w 1520"/>
                <a:gd name="T7" fmla="*/ 2 h 2"/>
                <a:gd name="T8" fmla="*/ 112 w 1520"/>
                <a:gd name="T9" fmla="*/ 2 h 2"/>
                <a:gd name="T10" fmla="*/ 138 w 1520"/>
                <a:gd name="T11" fmla="*/ 2 h 2"/>
                <a:gd name="T12" fmla="*/ 164 w 1520"/>
                <a:gd name="T13" fmla="*/ 2 h 2"/>
                <a:gd name="T14" fmla="*/ 191 w 1520"/>
                <a:gd name="T15" fmla="*/ 2 h 2"/>
                <a:gd name="T16" fmla="*/ 217 w 1520"/>
                <a:gd name="T17" fmla="*/ 2 h 2"/>
                <a:gd name="T18" fmla="*/ 243 w 1520"/>
                <a:gd name="T19" fmla="*/ 2 h 2"/>
                <a:gd name="T20" fmla="*/ 270 w 1520"/>
                <a:gd name="T21" fmla="*/ 2 h 2"/>
                <a:gd name="T22" fmla="*/ 296 w 1520"/>
                <a:gd name="T23" fmla="*/ 2 h 2"/>
                <a:gd name="T24" fmla="*/ 322 w 1520"/>
                <a:gd name="T25" fmla="*/ 2 h 2"/>
                <a:gd name="T26" fmla="*/ 349 w 1520"/>
                <a:gd name="T27" fmla="*/ 2 h 2"/>
                <a:gd name="T28" fmla="*/ 375 w 1520"/>
                <a:gd name="T29" fmla="*/ 2 h 2"/>
                <a:gd name="T30" fmla="*/ 401 w 1520"/>
                <a:gd name="T31" fmla="*/ 2 h 2"/>
                <a:gd name="T32" fmla="*/ 427 w 1520"/>
                <a:gd name="T33" fmla="*/ 2 h 2"/>
                <a:gd name="T34" fmla="*/ 454 w 1520"/>
                <a:gd name="T35" fmla="*/ 2 h 2"/>
                <a:gd name="T36" fmla="*/ 480 w 1520"/>
                <a:gd name="T37" fmla="*/ 2 h 2"/>
                <a:gd name="T38" fmla="*/ 506 w 1520"/>
                <a:gd name="T39" fmla="*/ 2 h 2"/>
                <a:gd name="T40" fmla="*/ 533 w 1520"/>
                <a:gd name="T41" fmla="*/ 2 h 2"/>
                <a:gd name="T42" fmla="*/ 559 w 1520"/>
                <a:gd name="T43" fmla="*/ 2 h 2"/>
                <a:gd name="T44" fmla="*/ 585 w 1520"/>
                <a:gd name="T45" fmla="*/ 2 h 2"/>
                <a:gd name="T46" fmla="*/ 612 w 1520"/>
                <a:gd name="T47" fmla="*/ 2 h 2"/>
                <a:gd name="T48" fmla="*/ 638 w 1520"/>
                <a:gd name="T49" fmla="*/ 2 h 2"/>
                <a:gd name="T50" fmla="*/ 664 w 1520"/>
                <a:gd name="T51" fmla="*/ 2 h 2"/>
                <a:gd name="T52" fmla="*/ 691 w 1520"/>
                <a:gd name="T53" fmla="*/ 2 h 2"/>
                <a:gd name="T54" fmla="*/ 717 w 1520"/>
                <a:gd name="T55" fmla="*/ 2 h 2"/>
                <a:gd name="T56" fmla="*/ 743 w 1520"/>
                <a:gd name="T57" fmla="*/ 2 h 2"/>
                <a:gd name="T58" fmla="*/ 770 w 1520"/>
                <a:gd name="T59" fmla="*/ 2 h 2"/>
                <a:gd name="T60" fmla="*/ 796 w 1520"/>
                <a:gd name="T61" fmla="*/ 2 h 2"/>
                <a:gd name="T62" fmla="*/ 822 w 1520"/>
                <a:gd name="T63" fmla="*/ 2 h 2"/>
                <a:gd name="T64" fmla="*/ 849 w 1520"/>
                <a:gd name="T65" fmla="*/ 2 h 2"/>
                <a:gd name="T66" fmla="*/ 875 w 1520"/>
                <a:gd name="T67" fmla="*/ 2 h 2"/>
                <a:gd name="T68" fmla="*/ 901 w 1520"/>
                <a:gd name="T69" fmla="*/ 2 h 2"/>
                <a:gd name="T70" fmla="*/ 928 w 1520"/>
                <a:gd name="T71" fmla="*/ 2 h 2"/>
                <a:gd name="T72" fmla="*/ 954 w 1520"/>
                <a:gd name="T73" fmla="*/ 2 h 2"/>
                <a:gd name="T74" fmla="*/ 980 w 1520"/>
                <a:gd name="T75" fmla="*/ 2 h 2"/>
                <a:gd name="T76" fmla="*/ 1007 w 1520"/>
                <a:gd name="T77" fmla="*/ 2 h 2"/>
                <a:gd name="T78" fmla="*/ 1033 w 1520"/>
                <a:gd name="T79" fmla="*/ 2 h 2"/>
                <a:gd name="T80" fmla="*/ 1059 w 1520"/>
                <a:gd name="T81" fmla="*/ 2 h 2"/>
                <a:gd name="T82" fmla="*/ 1086 w 1520"/>
                <a:gd name="T83" fmla="*/ 2 h 2"/>
                <a:gd name="T84" fmla="*/ 1112 w 1520"/>
                <a:gd name="T85" fmla="*/ 2 h 2"/>
                <a:gd name="T86" fmla="*/ 1138 w 1520"/>
                <a:gd name="T87" fmla="*/ 2 h 2"/>
                <a:gd name="T88" fmla="*/ 1164 w 1520"/>
                <a:gd name="T89" fmla="*/ 2 h 2"/>
                <a:gd name="T90" fmla="*/ 1191 w 1520"/>
                <a:gd name="T91" fmla="*/ 2 h 2"/>
                <a:gd name="T92" fmla="*/ 1217 w 1520"/>
                <a:gd name="T93" fmla="*/ 2 h 2"/>
                <a:gd name="T94" fmla="*/ 1243 w 1520"/>
                <a:gd name="T95" fmla="*/ 2 h 2"/>
                <a:gd name="T96" fmla="*/ 1270 w 1520"/>
                <a:gd name="T97" fmla="*/ 2 h 2"/>
                <a:gd name="T98" fmla="*/ 1296 w 1520"/>
                <a:gd name="T99" fmla="*/ 2 h 2"/>
                <a:gd name="T100" fmla="*/ 1322 w 1520"/>
                <a:gd name="T101" fmla="*/ 0 h 2"/>
                <a:gd name="T102" fmla="*/ 1349 w 1520"/>
                <a:gd name="T103" fmla="*/ 2 h 2"/>
                <a:gd name="T104" fmla="*/ 1375 w 1520"/>
                <a:gd name="T105" fmla="*/ 2 h 2"/>
                <a:gd name="T106" fmla="*/ 1401 w 1520"/>
                <a:gd name="T107" fmla="*/ 2 h 2"/>
                <a:gd name="T108" fmla="*/ 1428 w 1520"/>
                <a:gd name="T109" fmla="*/ 2 h 2"/>
                <a:gd name="T110" fmla="*/ 1454 w 1520"/>
                <a:gd name="T111" fmla="*/ 2 h 2"/>
                <a:gd name="T112" fmla="*/ 1480 w 1520"/>
                <a:gd name="T113" fmla="*/ 2 h 2"/>
                <a:gd name="T114" fmla="*/ 1507 w 1520"/>
                <a:gd name="T115" fmla="*/ 2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520" h="2">
                  <a:moveTo>
                    <a:pt x="0" y="2"/>
                  </a:moveTo>
                  <a:lnTo>
                    <a:pt x="0" y="2"/>
                  </a:lnTo>
                  <a:lnTo>
                    <a:pt x="4" y="2"/>
                  </a:lnTo>
                  <a:lnTo>
                    <a:pt x="9" y="2"/>
                  </a:lnTo>
                  <a:lnTo>
                    <a:pt x="13" y="2"/>
                  </a:lnTo>
                  <a:lnTo>
                    <a:pt x="20" y="2"/>
                  </a:lnTo>
                  <a:lnTo>
                    <a:pt x="26" y="2"/>
                  </a:lnTo>
                  <a:lnTo>
                    <a:pt x="33" y="2"/>
                  </a:lnTo>
                  <a:lnTo>
                    <a:pt x="39" y="2"/>
                  </a:lnTo>
                  <a:lnTo>
                    <a:pt x="46" y="2"/>
                  </a:lnTo>
                  <a:lnTo>
                    <a:pt x="52" y="2"/>
                  </a:lnTo>
                  <a:lnTo>
                    <a:pt x="59" y="2"/>
                  </a:lnTo>
                  <a:lnTo>
                    <a:pt x="66" y="2"/>
                  </a:lnTo>
                  <a:lnTo>
                    <a:pt x="72" y="2"/>
                  </a:lnTo>
                  <a:lnTo>
                    <a:pt x="79" y="2"/>
                  </a:lnTo>
                  <a:lnTo>
                    <a:pt x="85" y="2"/>
                  </a:lnTo>
                  <a:lnTo>
                    <a:pt x="92" y="2"/>
                  </a:lnTo>
                  <a:lnTo>
                    <a:pt x="98" y="2"/>
                  </a:lnTo>
                  <a:lnTo>
                    <a:pt x="105" y="2"/>
                  </a:lnTo>
                  <a:lnTo>
                    <a:pt x="112" y="2"/>
                  </a:lnTo>
                  <a:lnTo>
                    <a:pt x="118" y="2"/>
                  </a:lnTo>
                  <a:lnTo>
                    <a:pt x="125" y="2"/>
                  </a:lnTo>
                  <a:lnTo>
                    <a:pt x="131" y="2"/>
                  </a:lnTo>
                  <a:lnTo>
                    <a:pt x="138" y="2"/>
                  </a:lnTo>
                  <a:lnTo>
                    <a:pt x="145" y="2"/>
                  </a:lnTo>
                  <a:lnTo>
                    <a:pt x="151" y="2"/>
                  </a:lnTo>
                  <a:lnTo>
                    <a:pt x="158" y="2"/>
                  </a:lnTo>
                  <a:lnTo>
                    <a:pt x="164" y="2"/>
                  </a:lnTo>
                  <a:lnTo>
                    <a:pt x="171" y="2"/>
                  </a:lnTo>
                  <a:lnTo>
                    <a:pt x="177" y="2"/>
                  </a:lnTo>
                  <a:lnTo>
                    <a:pt x="184" y="2"/>
                  </a:lnTo>
                  <a:lnTo>
                    <a:pt x="191" y="2"/>
                  </a:lnTo>
                  <a:lnTo>
                    <a:pt x="197" y="2"/>
                  </a:lnTo>
                  <a:lnTo>
                    <a:pt x="204" y="2"/>
                  </a:lnTo>
                  <a:lnTo>
                    <a:pt x="210" y="2"/>
                  </a:lnTo>
                  <a:lnTo>
                    <a:pt x="217" y="2"/>
                  </a:lnTo>
                  <a:lnTo>
                    <a:pt x="224" y="2"/>
                  </a:lnTo>
                  <a:lnTo>
                    <a:pt x="230" y="2"/>
                  </a:lnTo>
                  <a:lnTo>
                    <a:pt x="237" y="0"/>
                  </a:lnTo>
                  <a:lnTo>
                    <a:pt x="243" y="2"/>
                  </a:lnTo>
                  <a:lnTo>
                    <a:pt x="250" y="2"/>
                  </a:lnTo>
                  <a:lnTo>
                    <a:pt x="256" y="2"/>
                  </a:lnTo>
                  <a:lnTo>
                    <a:pt x="263" y="2"/>
                  </a:lnTo>
                  <a:lnTo>
                    <a:pt x="270" y="2"/>
                  </a:lnTo>
                  <a:lnTo>
                    <a:pt x="276" y="2"/>
                  </a:lnTo>
                  <a:lnTo>
                    <a:pt x="283" y="2"/>
                  </a:lnTo>
                  <a:lnTo>
                    <a:pt x="289" y="2"/>
                  </a:lnTo>
                  <a:lnTo>
                    <a:pt x="296" y="2"/>
                  </a:lnTo>
                  <a:lnTo>
                    <a:pt x="302" y="2"/>
                  </a:lnTo>
                  <a:lnTo>
                    <a:pt x="309" y="2"/>
                  </a:lnTo>
                  <a:lnTo>
                    <a:pt x="316" y="2"/>
                  </a:lnTo>
                  <a:lnTo>
                    <a:pt x="322" y="2"/>
                  </a:lnTo>
                  <a:lnTo>
                    <a:pt x="329" y="2"/>
                  </a:lnTo>
                  <a:lnTo>
                    <a:pt x="335" y="2"/>
                  </a:lnTo>
                  <a:lnTo>
                    <a:pt x="342" y="2"/>
                  </a:lnTo>
                  <a:lnTo>
                    <a:pt x="349" y="2"/>
                  </a:lnTo>
                  <a:lnTo>
                    <a:pt x="355" y="2"/>
                  </a:lnTo>
                  <a:lnTo>
                    <a:pt x="362" y="2"/>
                  </a:lnTo>
                  <a:lnTo>
                    <a:pt x="368" y="2"/>
                  </a:lnTo>
                  <a:lnTo>
                    <a:pt x="375" y="2"/>
                  </a:lnTo>
                  <a:lnTo>
                    <a:pt x="381" y="2"/>
                  </a:lnTo>
                  <a:lnTo>
                    <a:pt x="388" y="2"/>
                  </a:lnTo>
                  <a:lnTo>
                    <a:pt x="395" y="2"/>
                  </a:lnTo>
                  <a:lnTo>
                    <a:pt x="401" y="2"/>
                  </a:lnTo>
                  <a:lnTo>
                    <a:pt x="408" y="2"/>
                  </a:lnTo>
                  <a:lnTo>
                    <a:pt x="414" y="2"/>
                  </a:lnTo>
                  <a:lnTo>
                    <a:pt x="421" y="2"/>
                  </a:lnTo>
                  <a:lnTo>
                    <a:pt x="427" y="2"/>
                  </a:lnTo>
                  <a:lnTo>
                    <a:pt x="434" y="2"/>
                  </a:lnTo>
                  <a:lnTo>
                    <a:pt x="441" y="2"/>
                  </a:lnTo>
                  <a:lnTo>
                    <a:pt x="447" y="2"/>
                  </a:lnTo>
                  <a:lnTo>
                    <a:pt x="454" y="2"/>
                  </a:lnTo>
                  <a:lnTo>
                    <a:pt x="460" y="2"/>
                  </a:lnTo>
                  <a:lnTo>
                    <a:pt x="467" y="2"/>
                  </a:lnTo>
                  <a:lnTo>
                    <a:pt x="474" y="2"/>
                  </a:lnTo>
                  <a:lnTo>
                    <a:pt x="480" y="2"/>
                  </a:lnTo>
                  <a:lnTo>
                    <a:pt x="487" y="2"/>
                  </a:lnTo>
                  <a:lnTo>
                    <a:pt x="493" y="2"/>
                  </a:lnTo>
                  <a:lnTo>
                    <a:pt x="500" y="0"/>
                  </a:lnTo>
                  <a:lnTo>
                    <a:pt x="506" y="2"/>
                  </a:lnTo>
                  <a:lnTo>
                    <a:pt x="513" y="2"/>
                  </a:lnTo>
                  <a:lnTo>
                    <a:pt x="520" y="2"/>
                  </a:lnTo>
                  <a:lnTo>
                    <a:pt x="526" y="2"/>
                  </a:lnTo>
                  <a:lnTo>
                    <a:pt x="533" y="2"/>
                  </a:lnTo>
                  <a:lnTo>
                    <a:pt x="539" y="2"/>
                  </a:lnTo>
                  <a:lnTo>
                    <a:pt x="546" y="2"/>
                  </a:lnTo>
                  <a:lnTo>
                    <a:pt x="552" y="2"/>
                  </a:lnTo>
                  <a:lnTo>
                    <a:pt x="559" y="2"/>
                  </a:lnTo>
                  <a:lnTo>
                    <a:pt x="566" y="2"/>
                  </a:lnTo>
                  <a:lnTo>
                    <a:pt x="572" y="2"/>
                  </a:lnTo>
                  <a:lnTo>
                    <a:pt x="579" y="2"/>
                  </a:lnTo>
                  <a:lnTo>
                    <a:pt x="585" y="2"/>
                  </a:lnTo>
                  <a:lnTo>
                    <a:pt x="592" y="2"/>
                  </a:lnTo>
                  <a:lnTo>
                    <a:pt x="599" y="2"/>
                  </a:lnTo>
                  <a:lnTo>
                    <a:pt x="605" y="2"/>
                  </a:lnTo>
                  <a:lnTo>
                    <a:pt x="612" y="2"/>
                  </a:lnTo>
                  <a:lnTo>
                    <a:pt x="618" y="2"/>
                  </a:lnTo>
                  <a:lnTo>
                    <a:pt x="625" y="2"/>
                  </a:lnTo>
                  <a:lnTo>
                    <a:pt x="631" y="2"/>
                  </a:lnTo>
                  <a:lnTo>
                    <a:pt x="638" y="2"/>
                  </a:lnTo>
                  <a:lnTo>
                    <a:pt x="645" y="2"/>
                  </a:lnTo>
                  <a:lnTo>
                    <a:pt x="651" y="2"/>
                  </a:lnTo>
                  <a:lnTo>
                    <a:pt x="658" y="2"/>
                  </a:lnTo>
                  <a:lnTo>
                    <a:pt x="664" y="2"/>
                  </a:lnTo>
                  <a:lnTo>
                    <a:pt x="671" y="2"/>
                  </a:lnTo>
                  <a:lnTo>
                    <a:pt x="678" y="2"/>
                  </a:lnTo>
                  <a:lnTo>
                    <a:pt x="684" y="2"/>
                  </a:lnTo>
                  <a:lnTo>
                    <a:pt x="691" y="2"/>
                  </a:lnTo>
                  <a:lnTo>
                    <a:pt x="697" y="2"/>
                  </a:lnTo>
                  <a:lnTo>
                    <a:pt x="704" y="2"/>
                  </a:lnTo>
                  <a:lnTo>
                    <a:pt x="710" y="2"/>
                  </a:lnTo>
                  <a:lnTo>
                    <a:pt x="717" y="2"/>
                  </a:lnTo>
                  <a:lnTo>
                    <a:pt x="724" y="2"/>
                  </a:lnTo>
                  <a:lnTo>
                    <a:pt x="730" y="2"/>
                  </a:lnTo>
                  <a:lnTo>
                    <a:pt x="737" y="2"/>
                  </a:lnTo>
                  <a:lnTo>
                    <a:pt x="743" y="2"/>
                  </a:lnTo>
                  <a:lnTo>
                    <a:pt x="750" y="2"/>
                  </a:lnTo>
                  <a:lnTo>
                    <a:pt x="756" y="2"/>
                  </a:lnTo>
                  <a:lnTo>
                    <a:pt x="763" y="2"/>
                  </a:lnTo>
                  <a:lnTo>
                    <a:pt x="770" y="2"/>
                  </a:lnTo>
                  <a:lnTo>
                    <a:pt x="776" y="2"/>
                  </a:lnTo>
                  <a:lnTo>
                    <a:pt x="783" y="2"/>
                  </a:lnTo>
                  <a:lnTo>
                    <a:pt x="789" y="2"/>
                  </a:lnTo>
                  <a:lnTo>
                    <a:pt x="796" y="2"/>
                  </a:lnTo>
                  <a:lnTo>
                    <a:pt x="803" y="2"/>
                  </a:lnTo>
                  <a:lnTo>
                    <a:pt x="809" y="2"/>
                  </a:lnTo>
                  <a:lnTo>
                    <a:pt x="816" y="2"/>
                  </a:lnTo>
                  <a:lnTo>
                    <a:pt x="822" y="2"/>
                  </a:lnTo>
                  <a:lnTo>
                    <a:pt x="829" y="2"/>
                  </a:lnTo>
                  <a:lnTo>
                    <a:pt x="835" y="2"/>
                  </a:lnTo>
                  <a:lnTo>
                    <a:pt x="842" y="2"/>
                  </a:lnTo>
                  <a:lnTo>
                    <a:pt x="849" y="2"/>
                  </a:lnTo>
                  <a:lnTo>
                    <a:pt x="855" y="2"/>
                  </a:lnTo>
                  <a:lnTo>
                    <a:pt x="862" y="2"/>
                  </a:lnTo>
                  <a:lnTo>
                    <a:pt x="868" y="2"/>
                  </a:lnTo>
                  <a:lnTo>
                    <a:pt x="875" y="2"/>
                  </a:lnTo>
                  <a:lnTo>
                    <a:pt x="882" y="2"/>
                  </a:lnTo>
                  <a:lnTo>
                    <a:pt x="888" y="2"/>
                  </a:lnTo>
                  <a:lnTo>
                    <a:pt x="895" y="2"/>
                  </a:lnTo>
                  <a:lnTo>
                    <a:pt x="901" y="2"/>
                  </a:lnTo>
                  <a:lnTo>
                    <a:pt x="908" y="2"/>
                  </a:lnTo>
                  <a:lnTo>
                    <a:pt x="914" y="2"/>
                  </a:lnTo>
                  <a:lnTo>
                    <a:pt x="921" y="2"/>
                  </a:lnTo>
                  <a:lnTo>
                    <a:pt x="928" y="2"/>
                  </a:lnTo>
                  <a:lnTo>
                    <a:pt x="934" y="2"/>
                  </a:lnTo>
                  <a:lnTo>
                    <a:pt x="941" y="2"/>
                  </a:lnTo>
                  <a:lnTo>
                    <a:pt x="947" y="2"/>
                  </a:lnTo>
                  <a:lnTo>
                    <a:pt x="954" y="2"/>
                  </a:lnTo>
                  <a:lnTo>
                    <a:pt x="960" y="2"/>
                  </a:lnTo>
                  <a:lnTo>
                    <a:pt x="967" y="2"/>
                  </a:lnTo>
                  <a:lnTo>
                    <a:pt x="974" y="2"/>
                  </a:lnTo>
                  <a:lnTo>
                    <a:pt x="980" y="2"/>
                  </a:lnTo>
                  <a:lnTo>
                    <a:pt x="987" y="2"/>
                  </a:lnTo>
                  <a:lnTo>
                    <a:pt x="993" y="2"/>
                  </a:lnTo>
                  <a:lnTo>
                    <a:pt x="1000" y="2"/>
                  </a:lnTo>
                  <a:lnTo>
                    <a:pt x="1007" y="2"/>
                  </a:lnTo>
                  <a:lnTo>
                    <a:pt x="1013" y="2"/>
                  </a:lnTo>
                  <a:lnTo>
                    <a:pt x="1020" y="2"/>
                  </a:lnTo>
                  <a:lnTo>
                    <a:pt x="1026" y="2"/>
                  </a:lnTo>
                  <a:lnTo>
                    <a:pt x="1033" y="2"/>
                  </a:lnTo>
                  <a:lnTo>
                    <a:pt x="1039" y="2"/>
                  </a:lnTo>
                  <a:lnTo>
                    <a:pt x="1046" y="2"/>
                  </a:lnTo>
                  <a:lnTo>
                    <a:pt x="1053" y="2"/>
                  </a:lnTo>
                  <a:lnTo>
                    <a:pt x="1059" y="2"/>
                  </a:lnTo>
                  <a:lnTo>
                    <a:pt x="1066" y="2"/>
                  </a:lnTo>
                  <a:lnTo>
                    <a:pt x="1072" y="2"/>
                  </a:lnTo>
                  <a:lnTo>
                    <a:pt x="1079" y="2"/>
                  </a:lnTo>
                  <a:lnTo>
                    <a:pt x="1086" y="2"/>
                  </a:lnTo>
                  <a:lnTo>
                    <a:pt x="1092" y="2"/>
                  </a:lnTo>
                  <a:lnTo>
                    <a:pt x="1099" y="2"/>
                  </a:lnTo>
                  <a:lnTo>
                    <a:pt x="1105" y="2"/>
                  </a:lnTo>
                  <a:lnTo>
                    <a:pt x="1112" y="2"/>
                  </a:lnTo>
                  <a:lnTo>
                    <a:pt x="1118" y="2"/>
                  </a:lnTo>
                  <a:lnTo>
                    <a:pt x="1125" y="2"/>
                  </a:lnTo>
                  <a:lnTo>
                    <a:pt x="1132" y="2"/>
                  </a:lnTo>
                  <a:lnTo>
                    <a:pt x="1138" y="2"/>
                  </a:lnTo>
                  <a:lnTo>
                    <a:pt x="1145" y="2"/>
                  </a:lnTo>
                  <a:lnTo>
                    <a:pt x="1151" y="2"/>
                  </a:lnTo>
                  <a:lnTo>
                    <a:pt x="1158" y="0"/>
                  </a:lnTo>
                  <a:lnTo>
                    <a:pt x="1164" y="2"/>
                  </a:lnTo>
                  <a:lnTo>
                    <a:pt x="1171" y="2"/>
                  </a:lnTo>
                  <a:lnTo>
                    <a:pt x="1178" y="2"/>
                  </a:lnTo>
                  <a:lnTo>
                    <a:pt x="1184" y="2"/>
                  </a:lnTo>
                  <a:lnTo>
                    <a:pt x="1191" y="2"/>
                  </a:lnTo>
                  <a:lnTo>
                    <a:pt x="1197" y="2"/>
                  </a:lnTo>
                  <a:lnTo>
                    <a:pt x="1204" y="2"/>
                  </a:lnTo>
                  <a:lnTo>
                    <a:pt x="1211" y="2"/>
                  </a:lnTo>
                  <a:lnTo>
                    <a:pt x="1217" y="2"/>
                  </a:lnTo>
                  <a:lnTo>
                    <a:pt x="1224" y="2"/>
                  </a:lnTo>
                  <a:lnTo>
                    <a:pt x="1230" y="2"/>
                  </a:lnTo>
                  <a:lnTo>
                    <a:pt x="1237" y="2"/>
                  </a:lnTo>
                  <a:lnTo>
                    <a:pt x="1243" y="2"/>
                  </a:lnTo>
                  <a:lnTo>
                    <a:pt x="1250" y="2"/>
                  </a:lnTo>
                  <a:lnTo>
                    <a:pt x="1257" y="2"/>
                  </a:lnTo>
                  <a:lnTo>
                    <a:pt x="1263" y="2"/>
                  </a:lnTo>
                  <a:lnTo>
                    <a:pt x="1270" y="2"/>
                  </a:lnTo>
                  <a:lnTo>
                    <a:pt x="1276" y="2"/>
                  </a:lnTo>
                  <a:lnTo>
                    <a:pt x="1283" y="2"/>
                  </a:lnTo>
                  <a:lnTo>
                    <a:pt x="1289" y="2"/>
                  </a:lnTo>
                  <a:lnTo>
                    <a:pt x="1296" y="2"/>
                  </a:lnTo>
                  <a:lnTo>
                    <a:pt x="1303" y="2"/>
                  </a:lnTo>
                  <a:lnTo>
                    <a:pt x="1309" y="2"/>
                  </a:lnTo>
                  <a:lnTo>
                    <a:pt x="1316" y="2"/>
                  </a:lnTo>
                  <a:lnTo>
                    <a:pt x="1322" y="0"/>
                  </a:lnTo>
                  <a:lnTo>
                    <a:pt x="1329" y="2"/>
                  </a:lnTo>
                  <a:lnTo>
                    <a:pt x="1336" y="2"/>
                  </a:lnTo>
                  <a:lnTo>
                    <a:pt x="1342" y="2"/>
                  </a:lnTo>
                  <a:lnTo>
                    <a:pt x="1349" y="2"/>
                  </a:lnTo>
                  <a:lnTo>
                    <a:pt x="1355" y="2"/>
                  </a:lnTo>
                  <a:lnTo>
                    <a:pt x="1362" y="2"/>
                  </a:lnTo>
                  <a:lnTo>
                    <a:pt x="1368" y="2"/>
                  </a:lnTo>
                  <a:lnTo>
                    <a:pt x="1375" y="2"/>
                  </a:lnTo>
                  <a:lnTo>
                    <a:pt x="1382" y="2"/>
                  </a:lnTo>
                  <a:lnTo>
                    <a:pt x="1388" y="2"/>
                  </a:lnTo>
                  <a:lnTo>
                    <a:pt x="1395" y="2"/>
                  </a:lnTo>
                  <a:lnTo>
                    <a:pt x="1401" y="2"/>
                  </a:lnTo>
                  <a:lnTo>
                    <a:pt x="1408" y="2"/>
                  </a:lnTo>
                  <a:lnTo>
                    <a:pt x="1415" y="2"/>
                  </a:lnTo>
                  <a:lnTo>
                    <a:pt x="1421" y="2"/>
                  </a:lnTo>
                  <a:lnTo>
                    <a:pt x="1428" y="2"/>
                  </a:lnTo>
                  <a:lnTo>
                    <a:pt x="1434" y="2"/>
                  </a:lnTo>
                  <a:lnTo>
                    <a:pt x="1441" y="2"/>
                  </a:lnTo>
                  <a:lnTo>
                    <a:pt x="1447" y="2"/>
                  </a:lnTo>
                  <a:lnTo>
                    <a:pt x="1454" y="2"/>
                  </a:lnTo>
                  <a:lnTo>
                    <a:pt x="1461" y="2"/>
                  </a:lnTo>
                  <a:lnTo>
                    <a:pt x="1467" y="2"/>
                  </a:lnTo>
                  <a:lnTo>
                    <a:pt x="1474" y="2"/>
                  </a:lnTo>
                  <a:lnTo>
                    <a:pt x="1480" y="2"/>
                  </a:lnTo>
                  <a:lnTo>
                    <a:pt x="1487" y="2"/>
                  </a:lnTo>
                  <a:lnTo>
                    <a:pt x="1493" y="2"/>
                  </a:lnTo>
                  <a:lnTo>
                    <a:pt x="1500" y="2"/>
                  </a:lnTo>
                  <a:lnTo>
                    <a:pt x="1507" y="2"/>
                  </a:lnTo>
                  <a:lnTo>
                    <a:pt x="1513" y="2"/>
                  </a:lnTo>
                  <a:lnTo>
                    <a:pt x="1520" y="2"/>
                  </a:lnTo>
                </a:path>
              </a:pathLst>
            </a:custGeom>
            <a:noFill/>
            <a:ln w="31750">
              <a:solidFill>
                <a:srgbClr val="8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191"/>
            <p:cNvSpPr>
              <a:spLocks/>
            </p:cNvSpPr>
            <p:nvPr/>
          </p:nvSpPr>
          <p:spPr bwMode="auto">
            <a:xfrm>
              <a:off x="2198688" y="2286000"/>
              <a:ext cx="6632575" cy="3779838"/>
            </a:xfrm>
            <a:custGeom>
              <a:avLst/>
              <a:gdLst>
                <a:gd name="T0" fmla="*/ 9 w 1518"/>
                <a:gd name="T1" fmla="*/ 865 h 865"/>
                <a:gd name="T2" fmla="*/ 26 w 1518"/>
                <a:gd name="T3" fmla="*/ 865 h 865"/>
                <a:gd name="T4" fmla="*/ 43 w 1518"/>
                <a:gd name="T5" fmla="*/ 865 h 865"/>
                <a:gd name="T6" fmla="*/ 64 w 1518"/>
                <a:gd name="T7" fmla="*/ 865 h 865"/>
                <a:gd name="T8" fmla="*/ 91 w 1518"/>
                <a:gd name="T9" fmla="*/ 865 h 865"/>
                <a:gd name="T10" fmla="*/ 117 w 1518"/>
                <a:gd name="T11" fmla="*/ 865 h 865"/>
                <a:gd name="T12" fmla="*/ 143 w 1518"/>
                <a:gd name="T13" fmla="*/ 865 h 865"/>
                <a:gd name="T14" fmla="*/ 170 w 1518"/>
                <a:gd name="T15" fmla="*/ 865 h 865"/>
                <a:gd name="T16" fmla="*/ 196 w 1518"/>
                <a:gd name="T17" fmla="*/ 865 h 865"/>
                <a:gd name="T18" fmla="*/ 222 w 1518"/>
                <a:gd name="T19" fmla="*/ 865 h 865"/>
                <a:gd name="T20" fmla="*/ 249 w 1518"/>
                <a:gd name="T21" fmla="*/ 865 h 865"/>
                <a:gd name="T22" fmla="*/ 275 w 1518"/>
                <a:gd name="T23" fmla="*/ 865 h 865"/>
                <a:gd name="T24" fmla="*/ 301 w 1518"/>
                <a:gd name="T25" fmla="*/ 865 h 865"/>
                <a:gd name="T26" fmla="*/ 327 w 1518"/>
                <a:gd name="T27" fmla="*/ 865 h 865"/>
                <a:gd name="T28" fmla="*/ 354 w 1518"/>
                <a:gd name="T29" fmla="*/ 865 h 865"/>
                <a:gd name="T30" fmla="*/ 380 w 1518"/>
                <a:gd name="T31" fmla="*/ 865 h 865"/>
                <a:gd name="T32" fmla="*/ 406 w 1518"/>
                <a:gd name="T33" fmla="*/ 865 h 865"/>
                <a:gd name="T34" fmla="*/ 433 w 1518"/>
                <a:gd name="T35" fmla="*/ 865 h 865"/>
                <a:gd name="T36" fmla="*/ 459 w 1518"/>
                <a:gd name="T37" fmla="*/ 865 h 865"/>
                <a:gd name="T38" fmla="*/ 485 w 1518"/>
                <a:gd name="T39" fmla="*/ 865 h 865"/>
                <a:gd name="T40" fmla="*/ 512 w 1518"/>
                <a:gd name="T41" fmla="*/ 865 h 865"/>
                <a:gd name="T42" fmla="*/ 538 w 1518"/>
                <a:gd name="T43" fmla="*/ 865 h 865"/>
                <a:gd name="T44" fmla="*/ 564 w 1518"/>
                <a:gd name="T45" fmla="*/ 865 h 865"/>
                <a:gd name="T46" fmla="*/ 591 w 1518"/>
                <a:gd name="T47" fmla="*/ 865 h 865"/>
                <a:gd name="T48" fmla="*/ 617 w 1518"/>
                <a:gd name="T49" fmla="*/ 865 h 865"/>
                <a:gd name="T50" fmla="*/ 643 w 1518"/>
                <a:gd name="T51" fmla="*/ 865 h 865"/>
                <a:gd name="T52" fmla="*/ 670 w 1518"/>
                <a:gd name="T53" fmla="*/ 865 h 865"/>
                <a:gd name="T54" fmla="*/ 696 w 1518"/>
                <a:gd name="T55" fmla="*/ 865 h 865"/>
                <a:gd name="T56" fmla="*/ 722 w 1518"/>
                <a:gd name="T57" fmla="*/ 865 h 865"/>
                <a:gd name="T58" fmla="*/ 749 w 1518"/>
                <a:gd name="T59" fmla="*/ 865 h 865"/>
                <a:gd name="T60" fmla="*/ 775 w 1518"/>
                <a:gd name="T61" fmla="*/ 865 h 865"/>
                <a:gd name="T62" fmla="*/ 801 w 1518"/>
                <a:gd name="T63" fmla="*/ 865 h 865"/>
                <a:gd name="T64" fmla="*/ 828 w 1518"/>
                <a:gd name="T65" fmla="*/ 865 h 865"/>
                <a:gd name="T66" fmla="*/ 854 w 1518"/>
                <a:gd name="T67" fmla="*/ 865 h 865"/>
                <a:gd name="T68" fmla="*/ 880 w 1518"/>
                <a:gd name="T69" fmla="*/ 865 h 865"/>
                <a:gd name="T70" fmla="*/ 907 w 1518"/>
                <a:gd name="T71" fmla="*/ 865 h 865"/>
                <a:gd name="T72" fmla="*/ 933 w 1518"/>
                <a:gd name="T73" fmla="*/ 865 h 865"/>
                <a:gd name="T74" fmla="*/ 959 w 1518"/>
                <a:gd name="T75" fmla="*/ 865 h 865"/>
                <a:gd name="T76" fmla="*/ 985 w 1518"/>
                <a:gd name="T77" fmla="*/ 865 h 865"/>
                <a:gd name="T78" fmla="*/ 1012 w 1518"/>
                <a:gd name="T79" fmla="*/ 865 h 865"/>
                <a:gd name="T80" fmla="*/ 1038 w 1518"/>
                <a:gd name="T81" fmla="*/ 865 h 865"/>
                <a:gd name="T82" fmla="*/ 1064 w 1518"/>
                <a:gd name="T83" fmla="*/ 865 h 865"/>
                <a:gd name="T84" fmla="*/ 1091 w 1518"/>
                <a:gd name="T85" fmla="*/ 865 h 865"/>
                <a:gd name="T86" fmla="*/ 1117 w 1518"/>
                <a:gd name="T87" fmla="*/ 865 h 865"/>
                <a:gd name="T88" fmla="*/ 1143 w 1518"/>
                <a:gd name="T89" fmla="*/ 865 h 865"/>
                <a:gd name="T90" fmla="*/ 1170 w 1518"/>
                <a:gd name="T91" fmla="*/ 863 h 865"/>
                <a:gd name="T92" fmla="*/ 1196 w 1518"/>
                <a:gd name="T93" fmla="*/ 865 h 865"/>
                <a:gd name="T94" fmla="*/ 1222 w 1518"/>
                <a:gd name="T95" fmla="*/ 0 h 865"/>
                <a:gd name="T96" fmla="*/ 1249 w 1518"/>
                <a:gd name="T97" fmla="*/ 854 h 865"/>
                <a:gd name="T98" fmla="*/ 1275 w 1518"/>
                <a:gd name="T99" fmla="*/ 865 h 865"/>
                <a:gd name="T100" fmla="*/ 1301 w 1518"/>
                <a:gd name="T101" fmla="*/ 865 h 865"/>
                <a:gd name="T102" fmla="*/ 1328 w 1518"/>
                <a:gd name="T103" fmla="*/ 863 h 865"/>
                <a:gd name="T104" fmla="*/ 1354 w 1518"/>
                <a:gd name="T105" fmla="*/ 865 h 865"/>
                <a:gd name="T106" fmla="*/ 1380 w 1518"/>
                <a:gd name="T107" fmla="*/ 865 h 865"/>
                <a:gd name="T108" fmla="*/ 1407 w 1518"/>
                <a:gd name="T109" fmla="*/ 865 h 865"/>
                <a:gd name="T110" fmla="*/ 1433 w 1518"/>
                <a:gd name="T111" fmla="*/ 865 h 865"/>
                <a:gd name="T112" fmla="*/ 1459 w 1518"/>
                <a:gd name="T113" fmla="*/ 865 h 865"/>
                <a:gd name="T114" fmla="*/ 1486 w 1518"/>
                <a:gd name="T115" fmla="*/ 865 h 865"/>
                <a:gd name="T116" fmla="*/ 1512 w 1518"/>
                <a:gd name="T117" fmla="*/ 865 h 8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518" h="865">
                  <a:moveTo>
                    <a:pt x="0" y="865"/>
                  </a:moveTo>
                  <a:lnTo>
                    <a:pt x="0" y="865"/>
                  </a:lnTo>
                  <a:lnTo>
                    <a:pt x="4" y="865"/>
                  </a:lnTo>
                  <a:lnTo>
                    <a:pt x="9" y="865"/>
                  </a:lnTo>
                  <a:lnTo>
                    <a:pt x="13" y="865"/>
                  </a:lnTo>
                  <a:lnTo>
                    <a:pt x="17" y="865"/>
                  </a:lnTo>
                  <a:lnTo>
                    <a:pt x="21" y="865"/>
                  </a:lnTo>
                  <a:lnTo>
                    <a:pt x="26" y="865"/>
                  </a:lnTo>
                  <a:lnTo>
                    <a:pt x="30" y="865"/>
                  </a:lnTo>
                  <a:lnTo>
                    <a:pt x="34" y="865"/>
                  </a:lnTo>
                  <a:lnTo>
                    <a:pt x="38" y="865"/>
                  </a:lnTo>
                  <a:lnTo>
                    <a:pt x="43" y="865"/>
                  </a:lnTo>
                  <a:lnTo>
                    <a:pt x="47" y="865"/>
                  </a:lnTo>
                  <a:lnTo>
                    <a:pt x="51" y="865"/>
                  </a:lnTo>
                  <a:lnTo>
                    <a:pt x="58" y="865"/>
                  </a:lnTo>
                  <a:lnTo>
                    <a:pt x="64" y="865"/>
                  </a:lnTo>
                  <a:lnTo>
                    <a:pt x="71" y="865"/>
                  </a:lnTo>
                  <a:lnTo>
                    <a:pt x="77" y="865"/>
                  </a:lnTo>
                  <a:lnTo>
                    <a:pt x="84" y="865"/>
                  </a:lnTo>
                  <a:lnTo>
                    <a:pt x="91" y="865"/>
                  </a:lnTo>
                  <a:lnTo>
                    <a:pt x="97" y="865"/>
                  </a:lnTo>
                  <a:lnTo>
                    <a:pt x="104" y="865"/>
                  </a:lnTo>
                  <a:lnTo>
                    <a:pt x="110" y="865"/>
                  </a:lnTo>
                  <a:lnTo>
                    <a:pt x="117" y="865"/>
                  </a:lnTo>
                  <a:lnTo>
                    <a:pt x="123" y="865"/>
                  </a:lnTo>
                  <a:lnTo>
                    <a:pt x="130" y="865"/>
                  </a:lnTo>
                  <a:lnTo>
                    <a:pt x="137" y="865"/>
                  </a:lnTo>
                  <a:lnTo>
                    <a:pt x="143" y="865"/>
                  </a:lnTo>
                  <a:lnTo>
                    <a:pt x="150" y="865"/>
                  </a:lnTo>
                  <a:lnTo>
                    <a:pt x="156" y="865"/>
                  </a:lnTo>
                  <a:lnTo>
                    <a:pt x="163" y="865"/>
                  </a:lnTo>
                  <a:lnTo>
                    <a:pt x="170" y="865"/>
                  </a:lnTo>
                  <a:lnTo>
                    <a:pt x="176" y="865"/>
                  </a:lnTo>
                  <a:lnTo>
                    <a:pt x="183" y="865"/>
                  </a:lnTo>
                  <a:lnTo>
                    <a:pt x="189" y="865"/>
                  </a:lnTo>
                  <a:lnTo>
                    <a:pt x="196" y="865"/>
                  </a:lnTo>
                  <a:lnTo>
                    <a:pt x="202" y="865"/>
                  </a:lnTo>
                  <a:lnTo>
                    <a:pt x="209" y="865"/>
                  </a:lnTo>
                  <a:lnTo>
                    <a:pt x="216" y="865"/>
                  </a:lnTo>
                  <a:lnTo>
                    <a:pt x="222" y="865"/>
                  </a:lnTo>
                  <a:lnTo>
                    <a:pt x="229" y="865"/>
                  </a:lnTo>
                  <a:lnTo>
                    <a:pt x="235" y="865"/>
                  </a:lnTo>
                  <a:lnTo>
                    <a:pt x="242" y="865"/>
                  </a:lnTo>
                  <a:lnTo>
                    <a:pt x="249" y="865"/>
                  </a:lnTo>
                  <a:lnTo>
                    <a:pt x="255" y="865"/>
                  </a:lnTo>
                  <a:lnTo>
                    <a:pt x="262" y="865"/>
                  </a:lnTo>
                  <a:lnTo>
                    <a:pt x="268" y="865"/>
                  </a:lnTo>
                  <a:lnTo>
                    <a:pt x="275" y="865"/>
                  </a:lnTo>
                  <a:lnTo>
                    <a:pt x="281" y="865"/>
                  </a:lnTo>
                  <a:lnTo>
                    <a:pt x="288" y="865"/>
                  </a:lnTo>
                  <a:lnTo>
                    <a:pt x="295" y="865"/>
                  </a:lnTo>
                  <a:lnTo>
                    <a:pt x="301" y="865"/>
                  </a:lnTo>
                  <a:lnTo>
                    <a:pt x="308" y="865"/>
                  </a:lnTo>
                  <a:lnTo>
                    <a:pt x="314" y="865"/>
                  </a:lnTo>
                  <a:lnTo>
                    <a:pt x="321" y="865"/>
                  </a:lnTo>
                  <a:lnTo>
                    <a:pt x="327" y="865"/>
                  </a:lnTo>
                  <a:lnTo>
                    <a:pt x="334" y="865"/>
                  </a:lnTo>
                  <a:lnTo>
                    <a:pt x="341" y="865"/>
                  </a:lnTo>
                  <a:lnTo>
                    <a:pt x="347" y="865"/>
                  </a:lnTo>
                  <a:lnTo>
                    <a:pt x="354" y="865"/>
                  </a:lnTo>
                  <a:lnTo>
                    <a:pt x="360" y="865"/>
                  </a:lnTo>
                  <a:lnTo>
                    <a:pt x="367" y="865"/>
                  </a:lnTo>
                  <a:lnTo>
                    <a:pt x="374" y="865"/>
                  </a:lnTo>
                  <a:lnTo>
                    <a:pt x="380" y="865"/>
                  </a:lnTo>
                  <a:lnTo>
                    <a:pt x="387" y="865"/>
                  </a:lnTo>
                  <a:lnTo>
                    <a:pt x="393" y="865"/>
                  </a:lnTo>
                  <a:lnTo>
                    <a:pt x="400" y="865"/>
                  </a:lnTo>
                  <a:lnTo>
                    <a:pt x="406" y="865"/>
                  </a:lnTo>
                  <a:lnTo>
                    <a:pt x="413" y="865"/>
                  </a:lnTo>
                  <a:lnTo>
                    <a:pt x="420" y="865"/>
                  </a:lnTo>
                  <a:lnTo>
                    <a:pt x="426" y="865"/>
                  </a:lnTo>
                  <a:lnTo>
                    <a:pt x="433" y="865"/>
                  </a:lnTo>
                  <a:lnTo>
                    <a:pt x="439" y="865"/>
                  </a:lnTo>
                  <a:lnTo>
                    <a:pt x="446" y="865"/>
                  </a:lnTo>
                  <a:lnTo>
                    <a:pt x="452" y="865"/>
                  </a:lnTo>
                  <a:lnTo>
                    <a:pt x="459" y="865"/>
                  </a:lnTo>
                  <a:lnTo>
                    <a:pt x="466" y="865"/>
                  </a:lnTo>
                  <a:lnTo>
                    <a:pt x="472" y="865"/>
                  </a:lnTo>
                  <a:lnTo>
                    <a:pt x="479" y="865"/>
                  </a:lnTo>
                  <a:lnTo>
                    <a:pt x="485" y="865"/>
                  </a:lnTo>
                  <a:lnTo>
                    <a:pt x="492" y="865"/>
                  </a:lnTo>
                  <a:lnTo>
                    <a:pt x="499" y="865"/>
                  </a:lnTo>
                  <a:lnTo>
                    <a:pt x="505" y="865"/>
                  </a:lnTo>
                  <a:lnTo>
                    <a:pt x="512" y="865"/>
                  </a:lnTo>
                  <a:lnTo>
                    <a:pt x="518" y="865"/>
                  </a:lnTo>
                  <a:lnTo>
                    <a:pt x="525" y="865"/>
                  </a:lnTo>
                  <a:lnTo>
                    <a:pt x="531" y="865"/>
                  </a:lnTo>
                  <a:lnTo>
                    <a:pt x="538" y="865"/>
                  </a:lnTo>
                  <a:lnTo>
                    <a:pt x="545" y="865"/>
                  </a:lnTo>
                  <a:lnTo>
                    <a:pt x="551" y="865"/>
                  </a:lnTo>
                  <a:lnTo>
                    <a:pt x="558" y="865"/>
                  </a:lnTo>
                  <a:lnTo>
                    <a:pt x="564" y="865"/>
                  </a:lnTo>
                  <a:lnTo>
                    <a:pt x="571" y="865"/>
                  </a:lnTo>
                  <a:lnTo>
                    <a:pt x="578" y="865"/>
                  </a:lnTo>
                  <a:lnTo>
                    <a:pt x="584" y="865"/>
                  </a:lnTo>
                  <a:lnTo>
                    <a:pt x="591" y="865"/>
                  </a:lnTo>
                  <a:lnTo>
                    <a:pt x="597" y="865"/>
                  </a:lnTo>
                  <a:lnTo>
                    <a:pt x="604" y="865"/>
                  </a:lnTo>
                  <a:lnTo>
                    <a:pt x="610" y="865"/>
                  </a:lnTo>
                  <a:lnTo>
                    <a:pt x="617" y="865"/>
                  </a:lnTo>
                  <a:lnTo>
                    <a:pt x="624" y="865"/>
                  </a:lnTo>
                  <a:lnTo>
                    <a:pt x="630" y="865"/>
                  </a:lnTo>
                  <a:lnTo>
                    <a:pt x="637" y="865"/>
                  </a:lnTo>
                  <a:lnTo>
                    <a:pt x="643" y="865"/>
                  </a:lnTo>
                  <a:lnTo>
                    <a:pt x="650" y="865"/>
                  </a:lnTo>
                  <a:lnTo>
                    <a:pt x="656" y="865"/>
                  </a:lnTo>
                  <a:lnTo>
                    <a:pt x="663" y="865"/>
                  </a:lnTo>
                  <a:lnTo>
                    <a:pt x="670" y="865"/>
                  </a:lnTo>
                  <a:lnTo>
                    <a:pt x="676" y="865"/>
                  </a:lnTo>
                  <a:lnTo>
                    <a:pt x="683" y="865"/>
                  </a:lnTo>
                  <a:lnTo>
                    <a:pt x="689" y="865"/>
                  </a:lnTo>
                  <a:lnTo>
                    <a:pt x="696" y="865"/>
                  </a:lnTo>
                  <a:lnTo>
                    <a:pt x="703" y="865"/>
                  </a:lnTo>
                  <a:lnTo>
                    <a:pt x="709" y="865"/>
                  </a:lnTo>
                  <a:lnTo>
                    <a:pt x="716" y="865"/>
                  </a:lnTo>
                  <a:lnTo>
                    <a:pt x="722" y="865"/>
                  </a:lnTo>
                  <a:lnTo>
                    <a:pt x="729" y="865"/>
                  </a:lnTo>
                  <a:lnTo>
                    <a:pt x="735" y="865"/>
                  </a:lnTo>
                  <a:lnTo>
                    <a:pt x="742" y="865"/>
                  </a:lnTo>
                  <a:lnTo>
                    <a:pt x="749" y="865"/>
                  </a:lnTo>
                  <a:lnTo>
                    <a:pt x="755" y="865"/>
                  </a:lnTo>
                  <a:lnTo>
                    <a:pt x="762" y="865"/>
                  </a:lnTo>
                  <a:lnTo>
                    <a:pt x="768" y="865"/>
                  </a:lnTo>
                  <a:lnTo>
                    <a:pt x="775" y="865"/>
                  </a:lnTo>
                  <a:lnTo>
                    <a:pt x="781" y="865"/>
                  </a:lnTo>
                  <a:lnTo>
                    <a:pt x="788" y="865"/>
                  </a:lnTo>
                  <a:lnTo>
                    <a:pt x="795" y="865"/>
                  </a:lnTo>
                  <a:lnTo>
                    <a:pt x="801" y="865"/>
                  </a:lnTo>
                  <a:lnTo>
                    <a:pt x="808" y="865"/>
                  </a:lnTo>
                  <a:lnTo>
                    <a:pt x="814" y="865"/>
                  </a:lnTo>
                  <a:lnTo>
                    <a:pt x="821" y="865"/>
                  </a:lnTo>
                  <a:lnTo>
                    <a:pt x="828" y="865"/>
                  </a:lnTo>
                  <a:lnTo>
                    <a:pt x="834" y="865"/>
                  </a:lnTo>
                  <a:lnTo>
                    <a:pt x="841" y="865"/>
                  </a:lnTo>
                  <a:lnTo>
                    <a:pt x="847" y="865"/>
                  </a:lnTo>
                  <a:lnTo>
                    <a:pt x="854" y="865"/>
                  </a:lnTo>
                  <a:lnTo>
                    <a:pt x="860" y="865"/>
                  </a:lnTo>
                  <a:lnTo>
                    <a:pt x="867" y="865"/>
                  </a:lnTo>
                  <a:lnTo>
                    <a:pt x="874" y="865"/>
                  </a:lnTo>
                  <a:lnTo>
                    <a:pt x="880" y="865"/>
                  </a:lnTo>
                  <a:lnTo>
                    <a:pt x="887" y="865"/>
                  </a:lnTo>
                  <a:lnTo>
                    <a:pt x="893" y="865"/>
                  </a:lnTo>
                  <a:lnTo>
                    <a:pt x="900" y="865"/>
                  </a:lnTo>
                  <a:lnTo>
                    <a:pt x="907" y="865"/>
                  </a:lnTo>
                  <a:lnTo>
                    <a:pt x="913" y="865"/>
                  </a:lnTo>
                  <a:lnTo>
                    <a:pt x="920" y="865"/>
                  </a:lnTo>
                  <a:lnTo>
                    <a:pt x="926" y="865"/>
                  </a:lnTo>
                  <a:lnTo>
                    <a:pt x="933" y="865"/>
                  </a:lnTo>
                  <a:lnTo>
                    <a:pt x="939" y="865"/>
                  </a:lnTo>
                  <a:lnTo>
                    <a:pt x="946" y="865"/>
                  </a:lnTo>
                  <a:lnTo>
                    <a:pt x="953" y="865"/>
                  </a:lnTo>
                  <a:lnTo>
                    <a:pt x="959" y="865"/>
                  </a:lnTo>
                  <a:lnTo>
                    <a:pt x="966" y="865"/>
                  </a:lnTo>
                  <a:lnTo>
                    <a:pt x="972" y="865"/>
                  </a:lnTo>
                  <a:lnTo>
                    <a:pt x="979" y="865"/>
                  </a:lnTo>
                  <a:lnTo>
                    <a:pt x="985" y="865"/>
                  </a:lnTo>
                  <a:lnTo>
                    <a:pt x="992" y="865"/>
                  </a:lnTo>
                  <a:lnTo>
                    <a:pt x="999" y="865"/>
                  </a:lnTo>
                  <a:lnTo>
                    <a:pt x="1005" y="865"/>
                  </a:lnTo>
                  <a:lnTo>
                    <a:pt x="1012" y="865"/>
                  </a:lnTo>
                  <a:lnTo>
                    <a:pt x="1018" y="865"/>
                  </a:lnTo>
                  <a:lnTo>
                    <a:pt x="1025" y="865"/>
                  </a:lnTo>
                  <a:lnTo>
                    <a:pt x="1032" y="865"/>
                  </a:lnTo>
                  <a:lnTo>
                    <a:pt x="1038" y="865"/>
                  </a:lnTo>
                  <a:lnTo>
                    <a:pt x="1045" y="865"/>
                  </a:lnTo>
                  <a:lnTo>
                    <a:pt x="1051" y="865"/>
                  </a:lnTo>
                  <a:lnTo>
                    <a:pt x="1058" y="865"/>
                  </a:lnTo>
                  <a:lnTo>
                    <a:pt x="1064" y="865"/>
                  </a:lnTo>
                  <a:lnTo>
                    <a:pt x="1071" y="865"/>
                  </a:lnTo>
                  <a:lnTo>
                    <a:pt x="1078" y="865"/>
                  </a:lnTo>
                  <a:lnTo>
                    <a:pt x="1084" y="865"/>
                  </a:lnTo>
                  <a:lnTo>
                    <a:pt x="1091" y="865"/>
                  </a:lnTo>
                  <a:lnTo>
                    <a:pt x="1097" y="865"/>
                  </a:lnTo>
                  <a:lnTo>
                    <a:pt x="1104" y="865"/>
                  </a:lnTo>
                  <a:lnTo>
                    <a:pt x="1110" y="865"/>
                  </a:lnTo>
                  <a:lnTo>
                    <a:pt x="1117" y="865"/>
                  </a:lnTo>
                  <a:lnTo>
                    <a:pt x="1124" y="865"/>
                  </a:lnTo>
                  <a:lnTo>
                    <a:pt x="1130" y="865"/>
                  </a:lnTo>
                  <a:lnTo>
                    <a:pt x="1137" y="865"/>
                  </a:lnTo>
                  <a:lnTo>
                    <a:pt x="1143" y="865"/>
                  </a:lnTo>
                  <a:lnTo>
                    <a:pt x="1150" y="865"/>
                  </a:lnTo>
                  <a:lnTo>
                    <a:pt x="1157" y="865"/>
                  </a:lnTo>
                  <a:lnTo>
                    <a:pt x="1163" y="865"/>
                  </a:lnTo>
                  <a:lnTo>
                    <a:pt x="1170" y="863"/>
                  </a:lnTo>
                  <a:lnTo>
                    <a:pt x="1176" y="865"/>
                  </a:lnTo>
                  <a:lnTo>
                    <a:pt x="1183" y="865"/>
                  </a:lnTo>
                  <a:lnTo>
                    <a:pt x="1189" y="865"/>
                  </a:lnTo>
                  <a:lnTo>
                    <a:pt x="1196" y="865"/>
                  </a:lnTo>
                  <a:lnTo>
                    <a:pt x="1203" y="865"/>
                  </a:lnTo>
                  <a:lnTo>
                    <a:pt x="1209" y="846"/>
                  </a:lnTo>
                  <a:lnTo>
                    <a:pt x="1216" y="431"/>
                  </a:lnTo>
                  <a:lnTo>
                    <a:pt x="1222" y="0"/>
                  </a:lnTo>
                  <a:lnTo>
                    <a:pt x="1229" y="163"/>
                  </a:lnTo>
                  <a:lnTo>
                    <a:pt x="1236" y="605"/>
                  </a:lnTo>
                  <a:lnTo>
                    <a:pt x="1242" y="783"/>
                  </a:lnTo>
                  <a:lnTo>
                    <a:pt x="1249" y="854"/>
                  </a:lnTo>
                  <a:lnTo>
                    <a:pt x="1255" y="854"/>
                  </a:lnTo>
                  <a:lnTo>
                    <a:pt x="1262" y="859"/>
                  </a:lnTo>
                  <a:lnTo>
                    <a:pt x="1268" y="865"/>
                  </a:lnTo>
                  <a:lnTo>
                    <a:pt x="1275" y="865"/>
                  </a:lnTo>
                  <a:lnTo>
                    <a:pt x="1282" y="865"/>
                  </a:lnTo>
                  <a:lnTo>
                    <a:pt x="1288" y="861"/>
                  </a:lnTo>
                  <a:lnTo>
                    <a:pt x="1295" y="865"/>
                  </a:lnTo>
                  <a:lnTo>
                    <a:pt x="1301" y="865"/>
                  </a:lnTo>
                  <a:lnTo>
                    <a:pt x="1308" y="865"/>
                  </a:lnTo>
                  <a:lnTo>
                    <a:pt x="1314" y="863"/>
                  </a:lnTo>
                  <a:lnTo>
                    <a:pt x="1321" y="865"/>
                  </a:lnTo>
                  <a:lnTo>
                    <a:pt x="1328" y="863"/>
                  </a:lnTo>
                  <a:lnTo>
                    <a:pt x="1334" y="865"/>
                  </a:lnTo>
                  <a:lnTo>
                    <a:pt x="1341" y="865"/>
                  </a:lnTo>
                  <a:lnTo>
                    <a:pt x="1347" y="863"/>
                  </a:lnTo>
                  <a:lnTo>
                    <a:pt x="1354" y="865"/>
                  </a:lnTo>
                  <a:lnTo>
                    <a:pt x="1361" y="863"/>
                  </a:lnTo>
                  <a:lnTo>
                    <a:pt x="1367" y="865"/>
                  </a:lnTo>
                  <a:lnTo>
                    <a:pt x="1374" y="861"/>
                  </a:lnTo>
                  <a:lnTo>
                    <a:pt x="1380" y="865"/>
                  </a:lnTo>
                  <a:lnTo>
                    <a:pt x="1387" y="865"/>
                  </a:lnTo>
                  <a:lnTo>
                    <a:pt x="1393" y="865"/>
                  </a:lnTo>
                  <a:lnTo>
                    <a:pt x="1400" y="865"/>
                  </a:lnTo>
                  <a:lnTo>
                    <a:pt x="1407" y="865"/>
                  </a:lnTo>
                  <a:lnTo>
                    <a:pt x="1413" y="863"/>
                  </a:lnTo>
                  <a:lnTo>
                    <a:pt x="1420" y="865"/>
                  </a:lnTo>
                  <a:lnTo>
                    <a:pt x="1426" y="865"/>
                  </a:lnTo>
                  <a:lnTo>
                    <a:pt x="1433" y="865"/>
                  </a:lnTo>
                  <a:lnTo>
                    <a:pt x="1440" y="865"/>
                  </a:lnTo>
                  <a:lnTo>
                    <a:pt x="1446" y="865"/>
                  </a:lnTo>
                  <a:lnTo>
                    <a:pt x="1453" y="865"/>
                  </a:lnTo>
                  <a:lnTo>
                    <a:pt x="1459" y="865"/>
                  </a:lnTo>
                  <a:lnTo>
                    <a:pt x="1466" y="865"/>
                  </a:lnTo>
                  <a:lnTo>
                    <a:pt x="1472" y="865"/>
                  </a:lnTo>
                  <a:lnTo>
                    <a:pt x="1479" y="865"/>
                  </a:lnTo>
                  <a:lnTo>
                    <a:pt x="1486" y="865"/>
                  </a:lnTo>
                  <a:lnTo>
                    <a:pt x="1492" y="865"/>
                  </a:lnTo>
                  <a:lnTo>
                    <a:pt x="1499" y="863"/>
                  </a:lnTo>
                  <a:lnTo>
                    <a:pt x="1505" y="865"/>
                  </a:lnTo>
                  <a:lnTo>
                    <a:pt x="1512" y="865"/>
                  </a:lnTo>
                  <a:lnTo>
                    <a:pt x="1518" y="865"/>
                  </a:lnTo>
                </a:path>
              </a:pathLst>
            </a:custGeom>
            <a:noFill/>
            <a:ln w="1905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Freeform 192"/>
            <p:cNvSpPr>
              <a:spLocks/>
            </p:cNvSpPr>
            <p:nvPr/>
          </p:nvSpPr>
          <p:spPr bwMode="auto">
            <a:xfrm>
              <a:off x="2198688" y="2333625"/>
              <a:ext cx="6646862" cy="3732213"/>
            </a:xfrm>
            <a:custGeom>
              <a:avLst/>
              <a:gdLst>
                <a:gd name="T0" fmla="*/ 9 w 1521"/>
                <a:gd name="T1" fmla="*/ 854 h 854"/>
                <a:gd name="T2" fmla="*/ 26 w 1521"/>
                <a:gd name="T3" fmla="*/ 854 h 854"/>
                <a:gd name="T4" fmla="*/ 43 w 1521"/>
                <a:gd name="T5" fmla="*/ 854 h 854"/>
                <a:gd name="T6" fmla="*/ 67 w 1521"/>
                <a:gd name="T7" fmla="*/ 854 h 854"/>
                <a:gd name="T8" fmla="*/ 93 w 1521"/>
                <a:gd name="T9" fmla="*/ 854 h 854"/>
                <a:gd name="T10" fmla="*/ 119 w 1521"/>
                <a:gd name="T11" fmla="*/ 854 h 854"/>
                <a:gd name="T12" fmla="*/ 146 w 1521"/>
                <a:gd name="T13" fmla="*/ 854 h 854"/>
                <a:gd name="T14" fmla="*/ 172 w 1521"/>
                <a:gd name="T15" fmla="*/ 854 h 854"/>
                <a:gd name="T16" fmla="*/ 198 w 1521"/>
                <a:gd name="T17" fmla="*/ 854 h 854"/>
                <a:gd name="T18" fmla="*/ 225 w 1521"/>
                <a:gd name="T19" fmla="*/ 854 h 854"/>
                <a:gd name="T20" fmla="*/ 251 w 1521"/>
                <a:gd name="T21" fmla="*/ 854 h 854"/>
                <a:gd name="T22" fmla="*/ 277 w 1521"/>
                <a:gd name="T23" fmla="*/ 854 h 854"/>
                <a:gd name="T24" fmla="*/ 303 w 1521"/>
                <a:gd name="T25" fmla="*/ 854 h 854"/>
                <a:gd name="T26" fmla="*/ 330 w 1521"/>
                <a:gd name="T27" fmla="*/ 854 h 854"/>
                <a:gd name="T28" fmla="*/ 356 w 1521"/>
                <a:gd name="T29" fmla="*/ 854 h 854"/>
                <a:gd name="T30" fmla="*/ 382 w 1521"/>
                <a:gd name="T31" fmla="*/ 854 h 854"/>
                <a:gd name="T32" fmla="*/ 409 w 1521"/>
                <a:gd name="T33" fmla="*/ 854 h 854"/>
                <a:gd name="T34" fmla="*/ 435 w 1521"/>
                <a:gd name="T35" fmla="*/ 854 h 854"/>
                <a:gd name="T36" fmla="*/ 461 w 1521"/>
                <a:gd name="T37" fmla="*/ 854 h 854"/>
                <a:gd name="T38" fmla="*/ 488 w 1521"/>
                <a:gd name="T39" fmla="*/ 854 h 854"/>
                <a:gd name="T40" fmla="*/ 514 w 1521"/>
                <a:gd name="T41" fmla="*/ 854 h 854"/>
                <a:gd name="T42" fmla="*/ 540 w 1521"/>
                <a:gd name="T43" fmla="*/ 854 h 854"/>
                <a:gd name="T44" fmla="*/ 567 w 1521"/>
                <a:gd name="T45" fmla="*/ 854 h 854"/>
                <a:gd name="T46" fmla="*/ 593 w 1521"/>
                <a:gd name="T47" fmla="*/ 854 h 854"/>
                <a:gd name="T48" fmla="*/ 619 w 1521"/>
                <a:gd name="T49" fmla="*/ 854 h 854"/>
                <a:gd name="T50" fmla="*/ 646 w 1521"/>
                <a:gd name="T51" fmla="*/ 854 h 854"/>
                <a:gd name="T52" fmla="*/ 672 w 1521"/>
                <a:gd name="T53" fmla="*/ 854 h 854"/>
                <a:gd name="T54" fmla="*/ 698 w 1521"/>
                <a:gd name="T55" fmla="*/ 854 h 854"/>
                <a:gd name="T56" fmla="*/ 725 w 1521"/>
                <a:gd name="T57" fmla="*/ 854 h 854"/>
                <a:gd name="T58" fmla="*/ 751 w 1521"/>
                <a:gd name="T59" fmla="*/ 854 h 854"/>
                <a:gd name="T60" fmla="*/ 777 w 1521"/>
                <a:gd name="T61" fmla="*/ 854 h 854"/>
                <a:gd name="T62" fmla="*/ 804 w 1521"/>
                <a:gd name="T63" fmla="*/ 854 h 854"/>
                <a:gd name="T64" fmla="*/ 830 w 1521"/>
                <a:gd name="T65" fmla="*/ 854 h 854"/>
                <a:gd name="T66" fmla="*/ 856 w 1521"/>
                <a:gd name="T67" fmla="*/ 854 h 854"/>
                <a:gd name="T68" fmla="*/ 883 w 1521"/>
                <a:gd name="T69" fmla="*/ 854 h 854"/>
                <a:gd name="T70" fmla="*/ 909 w 1521"/>
                <a:gd name="T71" fmla="*/ 854 h 854"/>
                <a:gd name="T72" fmla="*/ 935 w 1521"/>
                <a:gd name="T73" fmla="*/ 854 h 854"/>
                <a:gd name="T74" fmla="*/ 962 w 1521"/>
                <a:gd name="T75" fmla="*/ 854 h 854"/>
                <a:gd name="T76" fmla="*/ 988 w 1521"/>
                <a:gd name="T77" fmla="*/ 854 h 854"/>
                <a:gd name="T78" fmla="*/ 1014 w 1521"/>
                <a:gd name="T79" fmla="*/ 854 h 854"/>
                <a:gd name="T80" fmla="*/ 1040 w 1521"/>
                <a:gd name="T81" fmla="*/ 852 h 854"/>
                <a:gd name="T82" fmla="*/ 1067 w 1521"/>
                <a:gd name="T83" fmla="*/ 852 h 854"/>
                <a:gd name="T84" fmla="*/ 1093 w 1521"/>
                <a:gd name="T85" fmla="*/ 854 h 854"/>
                <a:gd name="T86" fmla="*/ 1119 w 1521"/>
                <a:gd name="T87" fmla="*/ 852 h 854"/>
                <a:gd name="T88" fmla="*/ 1146 w 1521"/>
                <a:gd name="T89" fmla="*/ 848 h 854"/>
                <a:gd name="T90" fmla="*/ 1172 w 1521"/>
                <a:gd name="T91" fmla="*/ 846 h 854"/>
                <a:gd name="T92" fmla="*/ 1198 w 1521"/>
                <a:gd name="T93" fmla="*/ 535 h 854"/>
                <a:gd name="T94" fmla="*/ 1225 w 1521"/>
                <a:gd name="T95" fmla="*/ 139 h 854"/>
                <a:gd name="T96" fmla="*/ 1251 w 1521"/>
                <a:gd name="T97" fmla="*/ 850 h 854"/>
                <a:gd name="T98" fmla="*/ 1277 w 1521"/>
                <a:gd name="T99" fmla="*/ 854 h 854"/>
                <a:gd name="T100" fmla="*/ 1304 w 1521"/>
                <a:gd name="T101" fmla="*/ 854 h 854"/>
                <a:gd name="T102" fmla="*/ 1330 w 1521"/>
                <a:gd name="T103" fmla="*/ 852 h 854"/>
                <a:gd name="T104" fmla="*/ 1356 w 1521"/>
                <a:gd name="T105" fmla="*/ 854 h 854"/>
                <a:gd name="T106" fmla="*/ 1383 w 1521"/>
                <a:gd name="T107" fmla="*/ 854 h 854"/>
                <a:gd name="T108" fmla="*/ 1409 w 1521"/>
                <a:gd name="T109" fmla="*/ 854 h 854"/>
                <a:gd name="T110" fmla="*/ 1435 w 1521"/>
                <a:gd name="T111" fmla="*/ 854 h 854"/>
                <a:gd name="T112" fmla="*/ 1462 w 1521"/>
                <a:gd name="T113" fmla="*/ 854 h 854"/>
                <a:gd name="T114" fmla="*/ 1488 w 1521"/>
                <a:gd name="T115" fmla="*/ 854 h 854"/>
                <a:gd name="T116" fmla="*/ 1514 w 1521"/>
                <a:gd name="T117" fmla="*/ 854 h 8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521" h="854">
                  <a:moveTo>
                    <a:pt x="0" y="854"/>
                  </a:moveTo>
                  <a:lnTo>
                    <a:pt x="0" y="854"/>
                  </a:lnTo>
                  <a:lnTo>
                    <a:pt x="4" y="854"/>
                  </a:lnTo>
                  <a:lnTo>
                    <a:pt x="9" y="854"/>
                  </a:lnTo>
                  <a:lnTo>
                    <a:pt x="13" y="854"/>
                  </a:lnTo>
                  <a:lnTo>
                    <a:pt x="17" y="854"/>
                  </a:lnTo>
                  <a:lnTo>
                    <a:pt x="21" y="854"/>
                  </a:lnTo>
                  <a:lnTo>
                    <a:pt x="26" y="854"/>
                  </a:lnTo>
                  <a:lnTo>
                    <a:pt x="30" y="854"/>
                  </a:lnTo>
                  <a:lnTo>
                    <a:pt x="34" y="854"/>
                  </a:lnTo>
                  <a:lnTo>
                    <a:pt x="38" y="854"/>
                  </a:lnTo>
                  <a:lnTo>
                    <a:pt x="43" y="854"/>
                  </a:lnTo>
                  <a:lnTo>
                    <a:pt x="47" y="854"/>
                  </a:lnTo>
                  <a:lnTo>
                    <a:pt x="53" y="852"/>
                  </a:lnTo>
                  <a:lnTo>
                    <a:pt x="60" y="854"/>
                  </a:lnTo>
                  <a:lnTo>
                    <a:pt x="67" y="854"/>
                  </a:lnTo>
                  <a:lnTo>
                    <a:pt x="73" y="852"/>
                  </a:lnTo>
                  <a:lnTo>
                    <a:pt x="80" y="854"/>
                  </a:lnTo>
                  <a:lnTo>
                    <a:pt x="86" y="854"/>
                  </a:lnTo>
                  <a:lnTo>
                    <a:pt x="93" y="854"/>
                  </a:lnTo>
                  <a:lnTo>
                    <a:pt x="100" y="854"/>
                  </a:lnTo>
                  <a:lnTo>
                    <a:pt x="106" y="854"/>
                  </a:lnTo>
                  <a:lnTo>
                    <a:pt x="113" y="854"/>
                  </a:lnTo>
                  <a:lnTo>
                    <a:pt x="119" y="854"/>
                  </a:lnTo>
                  <a:lnTo>
                    <a:pt x="126" y="854"/>
                  </a:lnTo>
                  <a:lnTo>
                    <a:pt x="132" y="854"/>
                  </a:lnTo>
                  <a:lnTo>
                    <a:pt x="139" y="854"/>
                  </a:lnTo>
                  <a:lnTo>
                    <a:pt x="146" y="854"/>
                  </a:lnTo>
                  <a:lnTo>
                    <a:pt x="152" y="854"/>
                  </a:lnTo>
                  <a:lnTo>
                    <a:pt x="159" y="854"/>
                  </a:lnTo>
                  <a:lnTo>
                    <a:pt x="165" y="854"/>
                  </a:lnTo>
                  <a:lnTo>
                    <a:pt x="172" y="854"/>
                  </a:lnTo>
                  <a:lnTo>
                    <a:pt x="178" y="854"/>
                  </a:lnTo>
                  <a:lnTo>
                    <a:pt x="185" y="854"/>
                  </a:lnTo>
                  <a:lnTo>
                    <a:pt x="192" y="854"/>
                  </a:lnTo>
                  <a:lnTo>
                    <a:pt x="198" y="854"/>
                  </a:lnTo>
                  <a:lnTo>
                    <a:pt x="205" y="854"/>
                  </a:lnTo>
                  <a:lnTo>
                    <a:pt x="211" y="852"/>
                  </a:lnTo>
                  <a:lnTo>
                    <a:pt x="218" y="854"/>
                  </a:lnTo>
                  <a:lnTo>
                    <a:pt x="225" y="854"/>
                  </a:lnTo>
                  <a:lnTo>
                    <a:pt x="231" y="854"/>
                  </a:lnTo>
                  <a:lnTo>
                    <a:pt x="238" y="854"/>
                  </a:lnTo>
                  <a:lnTo>
                    <a:pt x="244" y="854"/>
                  </a:lnTo>
                  <a:lnTo>
                    <a:pt x="251" y="854"/>
                  </a:lnTo>
                  <a:lnTo>
                    <a:pt x="257" y="854"/>
                  </a:lnTo>
                  <a:lnTo>
                    <a:pt x="264" y="854"/>
                  </a:lnTo>
                  <a:lnTo>
                    <a:pt x="271" y="854"/>
                  </a:lnTo>
                  <a:lnTo>
                    <a:pt x="277" y="854"/>
                  </a:lnTo>
                  <a:lnTo>
                    <a:pt x="284" y="854"/>
                  </a:lnTo>
                  <a:lnTo>
                    <a:pt x="290" y="854"/>
                  </a:lnTo>
                  <a:lnTo>
                    <a:pt x="297" y="854"/>
                  </a:lnTo>
                  <a:lnTo>
                    <a:pt x="303" y="854"/>
                  </a:lnTo>
                  <a:lnTo>
                    <a:pt x="310" y="854"/>
                  </a:lnTo>
                  <a:lnTo>
                    <a:pt x="317" y="854"/>
                  </a:lnTo>
                  <a:lnTo>
                    <a:pt x="323" y="854"/>
                  </a:lnTo>
                  <a:lnTo>
                    <a:pt x="330" y="854"/>
                  </a:lnTo>
                  <a:lnTo>
                    <a:pt x="336" y="854"/>
                  </a:lnTo>
                  <a:lnTo>
                    <a:pt x="343" y="854"/>
                  </a:lnTo>
                  <a:lnTo>
                    <a:pt x="350" y="854"/>
                  </a:lnTo>
                  <a:lnTo>
                    <a:pt x="356" y="854"/>
                  </a:lnTo>
                  <a:lnTo>
                    <a:pt x="363" y="854"/>
                  </a:lnTo>
                  <a:lnTo>
                    <a:pt x="369" y="854"/>
                  </a:lnTo>
                  <a:lnTo>
                    <a:pt x="376" y="854"/>
                  </a:lnTo>
                  <a:lnTo>
                    <a:pt x="382" y="854"/>
                  </a:lnTo>
                  <a:lnTo>
                    <a:pt x="389" y="854"/>
                  </a:lnTo>
                  <a:lnTo>
                    <a:pt x="396" y="854"/>
                  </a:lnTo>
                  <a:lnTo>
                    <a:pt x="402" y="854"/>
                  </a:lnTo>
                  <a:lnTo>
                    <a:pt x="409" y="854"/>
                  </a:lnTo>
                  <a:lnTo>
                    <a:pt x="415" y="854"/>
                  </a:lnTo>
                  <a:lnTo>
                    <a:pt x="422" y="854"/>
                  </a:lnTo>
                  <a:lnTo>
                    <a:pt x="429" y="854"/>
                  </a:lnTo>
                  <a:lnTo>
                    <a:pt x="435" y="854"/>
                  </a:lnTo>
                  <a:lnTo>
                    <a:pt x="442" y="854"/>
                  </a:lnTo>
                  <a:lnTo>
                    <a:pt x="448" y="854"/>
                  </a:lnTo>
                  <a:lnTo>
                    <a:pt x="455" y="854"/>
                  </a:lnTo>
                  <a:lnTo>
                    <a:pt x="461" y="854"/>
                  </a:lnTo>
                  <a:lnTo>
                    <a:pt x="468" y="854"/>
                  </a:lnTo>
                  <a:lnTo>
                    <a:pt x="475" y="854"/>
                  </a:lnTo>
                  <a:lnTo>
                    <a:pt x="481" y="854"/>
                  </a:lnTo>
                  <a:lnTo>
                    <a:pt x="488" y="854"/>
                  </a:lnTo>
                  <a:lnTo>
                    <a:pt x="494" y="854"/>
                  </a:lnTo>
                  <a:lnTo>
                    <a:pt x="501" y="854"/>
                  </a:lnTo>
                  <a:lnTo>
                    <a:pt x="507" y="854"/>
                  </a:lnTo>
                  <a:lnTo>
                    <a:pt x="514" y="854"/>
                  </a:lnTo>
                  <a:lnTo>
                    <a:pt x="521" y="854"/>
                  </a:lnTo>
                  <a:lnTo>
                    <a:pt x="527" y="854"/>
                  </a:lnTo>
                  <a:lnTo>
                    <a:pt x="534" y="854"/>
                  </a:lnTo>
                  <a:lnTo>
                    <a:pt x="540" y="854"/>
                  </a:lnTo>
                  <a:lnTo>
                    <a:pt x="547" y="854"/>
                  </a:lnTo>
                  <a:lnTo>
                    <a:pt x="554" y="854"/>
                  </a:lnTo>
                  <a:lnTo>
                    <a:pt x="560" y="854"/>
                  </a:lnTo>
                  <a:lnTo>
                    <a:pt x="567" y="854"/>
                  </a:lnTo>
                  <a:lnTo>
                    <a:pt x="573" y="854"/>
                  </a:lnTo>
                  <a:lnTo>
                    <a:pt x="580" y="854"/>
                  </a:lnTo>
                  <a:lnTo>
                    <a:pt x="586" y="854"/>
                  </a:lnTo>
                  <a:lnTo>
                    <a:pt x="593" y="854"/>
                  </a:lnTo>
                  <a:lnTo>
                    <a:pt x="600" y="854"/>
                  </a:lnTo>
                  <a:lnTo>
                    <a:pt x="606" y="854"/>
                  </a:lnTo>
                  <a:lnTo>
                    <a:pt x="613" y="854"/>
                  </a:lnTo>
                  <a:lnTo>
                    <a:pt x="619" y="854"/>
                  </a:lnTo>
                  <a:lnTo>
                    <a:pt x="626" y="854"/>
                  </a:lnTo>
                  <a:lnTo>
                    <a:pt x="633" y="854"/>
                  </a:lnTo>
                  <a:lnTo>
                    <a:pt x="639" y="854"/>
                  </a:lnTo>
                  <a:lnTo>
                    <a:pt x="646" y="854"/>
                  </a:lnTo>
                  <a:lnTo>
                    <a:pt x="652" y="854"/>
                  </a:lnTo>
                  <a:lnTo>
                    <a:pt x="659" y="854"/>
                  </a:lnTo>
                  <a:lnTo>
                    <a:pt x="665" y="854"/>
                  </a:lnTo>
                  <a:lnTo>
                    <a:pt x="672" y="854"/>
                  </a:lnTo>
                  <a:lnTo>
                    <a:pt x="679" y="854"/>
                  </a:lnTo>
                  <a:lnTo>
                    <a:pt x="685" y="854"/>
                  </a:lnTo>
                  <a:lnTo>
                    <a:pt x="692" y="854"/>
                  </a:lnTo>
                  <a:lnTo>
                    <a:pt x="698" y="854"/>
                  </a:lnTo>
                  <a:lnTo>
                    <a:pt x="705" y="854"/>
                  </a:lnTo>
                  <a:lnTo>
                    <a:pt x="711" y="854"/>
                  </a:lnTo>
                  <a:lnTo>
                    <a:pt x="718" y="854"/>
                  </a:lnTo>
                  <a:lnTo>
                    <a:pt x="725" y="854"/>
                  </a:lnTo>
                  <a:lnTo>
                    <a:pt x="731" y="854"/>
                  </a:lnTo>
                  <a:lnTo>
                    <a:pt x="738" y="854"/>
                  </a:lnTo>
                  <a:lnTo>
                    <a:pt x="744" y="854"/>
                  </a:lnTo>
                  <a:lnTo>
                    <a:pt x="751" y="854"/>
                  </a:lnTo>
                  <a:lnTo>
                    <a:pt x="758" y="854"/>
                  </a:lnTo>
                  <a:lnTo>
                    <a:pt x="764" y="854"/>
                  </a:lnTo>
                  <a:lnTo>
                    <a:pt x="771" y="854"/>
                  </a:lnTo>
                  <a:lnTo>
                    <a:pt x="777" y="854"/>
                  </a:lnTo>
                  <a:lnTo>
                    <a:pt x="784" y="854"/>
                  </a:lnTo>
                  <a:lnTo>
                    <a:pt x="790" y="854"/>
                  </a:lnTo>
                  <a:lnTo>
                    <a:pt x="797" y="854"/>
                  </a:lnTo>
                  <a:lnTo>
                    <a:pt x="804" y="854"/>
                  </a:lnTo>
                  <a:lnTo>
                    <a:pt x="810" y="854"/>
                  </a:lnTo>
                  <a:lnTo>
                    <a:pt x="817" y="854"/>
                  </a:lnTo>
                  <a:lnTo>
                    <a:pt x="823" y="854"/>
                  </a:lnTo>
                  <a:lnTo>
                    <a:pt x="830" y="854"/>
                  </a:lnTo>
                  <a:lnTo>
                    <a:pt x="836" y="854"/>
                  </a:lnTo>
                  <a:lnTo>
                    <a:pt x="843" y="854"/>
                  </a:lnTo>
                  <a:lnTo>
                    <a:pt x="850" y="854"/>
                  </a:lnTo>
                  <a:lnTo>
                    <a:pt x="856" y="854"/>
                  </a:lnTo>
                  <a:lnTo>
                    <a:pt x="863" y="854"/>
                  </a:lnTo>
                  <a:lnTo>
                    <a:pt x="869" y="854"/>
                  </a:lnTo>
                  <a:lnTo>
                    <a:pt x="876" y="854"/>
                  </a:lnTo>
                  <a:lnTo>
                    <a:pt x="883" y="854"/>
                  </a:lnTo>
                  <a:lnTo>
                    <a:pt x="889" y="854"/>
                  </a:lnTo>
                  <a:lnTo>
                    <a:pt x="896" y="854"/>
                  </a:lnTo>
                  <a:lnTo>
                    <a:pt x="902" y="854"/>
                  </a:lnTo>
                  <a:lnTo>
                    <a:pt x="909" y="854"/>
                  </a:lnTo>
                  <a:lnTo>
                    <a:pt x="915" y="854"/>
                  </a:lnTo>
                  <a:lnTo>
                    <a:pt x="922" y="854"/>
                  </a:lnTo>
                  <a:lnTo>
                    <a:pt x="929" y="854"/>
                  </a:lnTo>
                  <a:lnTo>
                    <a:pt x="935" y="854"/>
                  </a:lnTo>
                  <a:lnTo>
                    <a:pt x="942" y="854"/>
                  </a:lnTo>
                  <a:lnTo>
                    <a:pt x="948" y="854"/>
                  </a:lnTo>
                  <a:lnTo>
                    <a:pt x="955" y="854"/>
                  </a:lnTo>
                  <a:lnTo>
                    <a:pt x="962" y="854"/>
                  </a:lnTo>
                  <a:lnTo>
                    <a:pt x="968" y="854"/>
                  </a:lnTo>
                  <a:lnTo>
                    <a:pt x="975" y="854"/>
                  </a:lnTo>
                  <a:lnTo>
                    <a:pt x="981" y="852"/>
                  </a:lnTo>
                  <a:lnTo>
                    <a:pt x="988" y="854"/>
                  </a:lnTo>
                  <a:lnTo>
                    <a:pt x="994" y="854"/>
                  </a:lnTo>
                  <a:lnTo>
                    <a:pt x="1001" y="854"/>
                  </a:lnTo>
                  <a:lnTo>
                    <a:pt x="1008" y="854"/>
                  </a:lnTo>
                  <a:lnTo>
                    <a:pt x="1014" y="854"/>
                  </a:lnTo>
                  <a:lnTo>
                    <a:pt x="1021" y="854"/>
                  </a:lnTo>
                  <a:lnTo>
                    <a:pt x="1027" y="854"/>
                  </a:lnTo>
                  <a:lnTo>
                    <a:pt x="1034" y="854"/>
                  </a:lnTo>
                  <a:lnTo>
                    <a:pt x="1040" y="852"/>
                  </a:lnTo>
                  <a:lnTo>
                    <a:pt x="1047" y="854"/>
                  </a:lnTo>
                  <a:lnTo>
                    <a:pt x="1054" y="852"/>
                  </a:lnTo>
                  <a:lnTo>
                    <a:pt x="1060" y="854"/>
                  </a:lnTo>
                  <a:lnTo>
                    <a:pt x="1067" y="852"/>
                  </a:lnTo>
                  <a:lnTo>
                    <a:pt x="1073" y="854"/>
                  </a:lnTo>
                  <a:lnTo>
                    <a:pt x="1080" y="854"/>
                  </a:lnTo>
                  <a:lnTo>
                    <a:pt x="1087" y="854"/>
                  </a:lnTo>
                  <a:lnTo>
                    <a:pt x="1093" y="854"/>
                  </a:lnTo>
                  <a:lnTo>
                    <a:pt x="1100" y="854"/>
                  </a:lnTo>
                  <a:lnTo>
                    <a:pt x="1106" y="854"/>
                  </a:lnTo>
                  <a:lnTo>
                    <a:pt x="1113" y="854"/>
                  </a:lnTo>
                  <a:lnTo>
                    <a:pt x="1119" y="852"/>
                  </a:lnTo>
                  <a:lnTo>
                    <a:pt x="1126" y="854"/>
                  </a:lnTo>
                  <a:lnTo>
                    <a:pt x="1133" y="852"/>
                  </a:lnTo>
                  <a:lnTo>
                    <a:pt x="1139" y="852"/>
                  </a:lnTo>
                  <a:lnTo>
                    <a:pt x="1146" y="848"/>
                  </a:lnTo>
                  <a:lnTo>
                    <a:pt x="1152" y="848"/>
                  </a:lnTo>
                  <a:lnTo>
                    <a:pt x="1159" y="846"/>
                  </a:lnTo>
                  <a:lnTo>
                    <a:pt x="1165" y="848"/>
                  </a:lnTo>
                  <a:lnTo>
                    <a:pt x="1172" y="846"/>
                  </a:lnTo>
                  <a:lnTo>
                    <a:pt x="1179" y="829"/>
                  </a:lnTo>
                  <a:lnTo>
                    <a:pt x="1185" y="805"/>
                  </a:lnTo>
                  <a:lnTo>
                    <a:pt x="1192" y="742"/>
                  </a:lnTo>
                  <a:lnTo>
                    <a:pt x="1198" y="535"/>
                  </a:lnTo>
                  <a:lnTo>
                    <a:pt x="1205" y="268"/>
                  </a:lnTo>
                  <a:lnTo>
                    <a:pt x="1212" y="171"/>
                  </a:lnTo>
                  <a:lnTo>
                    <a:pt x="1218" y="0"/>
                  </a:lnTo>
                  <a:lnTo>
                    <a:pt x="1225" y="139"/>
                  </a:lnTo>
                  <a:lnTo>
                    <a:pt x="1231" y="348"/>
                  </a:lnTo>
                  <a:lnTo>
                    <a:pt x="1238" y="689"/>
                  </a:lnTo>
                  <a:lnTo>
                    <a:pt x="1244" y="816"/>
                  </a:lnTo>
                  <a:lnTo>
                    <a:pt x="1251" y="850"/>
                  </a:lnTo>
                  <a:lnTo>
                    <a:pt x="1258" y="850"/>
                  </a:lnTo>
                  <a:lnTo>
                    <a:pt x="1264" y="852"/>
                  </a:lnTo>
                  <a:lnTo>
                    <a:pt x="1271" y="852"/>
                  </a:lnTo>
                  <a:lnTo>
                    <a:pt x="1277" y="854"/>
                  </a:lnTo>
                  <a:lnTo>
                    <a:pt x="1284" y="854"/>
                  </a:lnTo>
                  <a:lnTo>
                    <a:pt x="1291" y="854"/>
                  </a:lnTo>
                  <a:lnTo>
                    <a:pt x="1297" y="852"/>
                  </a:lnTo>
                  <a:lnTo>
                    <a:pt x="1304" y="854"/>
                  </a:lnTo>
                  <a:lnTo>
                    <a:pt x="1310" y="854"/>
                  </a:lnTo>
                  <a:lnTo>
                    <a:pt x="1317" y="854"/>
                  </a:lnTo>
                  <a:lnTo>
                    <a:pt x="1323" y="850"/>
                  </a:lnTo>
                  <a:lnTo>
                    <a:pt x="1330" y="852"/>
                  </a:lnTo>
                  <a:lnTo>
                    <a:pt x="1337" y="854"/>
                  </a:lnTo>
                  <a:lnTo>
                    <a:pt x="1343" y="854"/>
                  </a:lnTo>
                  <a:lnTo>
                    <a:pt x="1350" y="854"/>
                  </a:lnTo>
                  <a:lnTo>
                    <a:pt x="1356" y="854"/>
                  </a:lnTo>
                  <a:lnTo>
                    <a:pt x="1363" y="852"/>
                  </a:lnTo>
                  <a:lnTo>
                    <a:pt x="1369" y="854"/>
                  </a:lnTo>
                  <a:lnTo>
                    <a:pt x="1376" y="854"/>
                  </a:lnTo>
                  <a:lnTo>
                    <a:pt x="1383" y="854"/>
                  </a:lnTo>
                  <a:lnTo>
                    <a:pt x="1389" y="852"/>
                  </a:lnTo>
                  <a:lnTo>
                    <a:pt x="1396" y="852"/>
                  </a:lnTo>
                  <a:lnTo>
                    <a:pt x="1402" y="854"/>
                  </a:lnTo>
                  <a:lnTo>
                    <a:pt x="1409" y="854"/>
                  </a:lnTo>
                  <a:lnTo>
                    <a:pt x="1416" y="854"/>
                  </a:lnTo>
                  <a:lnTo>
                    <a:pt x="1422" y="854"/>
                  </a:lnTo>
                  <a:lnTo>
                    <a:pt x="1429" y="854"/>
                  </a:lnTo>
                  <a:lnTo>
                    <a:pt x="1435" y="854"/>
                  </a:lnTo>
                  <a:lnTo>
                    <a:pt x="1442" y="854"/>
                  </a:lnTo>
                  <a:lnTo>
                    <a:pt x="1448" y="854"/>
                  </a:lnTo>
                  <a:lnTo>
                    <a:pt x="1455" y="852"/>
                  </a:lnTo>
                  <a:lnTo>
                    <a:pt x="1462" y="854"/>
                  </a:lnTo>
                  <a:lnTo>
                    <a:pt x="1468" y="854"/>
                  </a:lnTo>
                  <a:lnTo>
                    <a:pt x="1475" y="854"/>
                  </a:lnTo>
                  <a:lnTo>
                    <a:pt x="1481" y="854"/>
                  </a:lnTo>
                  <a:lnTo>
                    <a:pt x="1488" y="854"/>
                  </a:lnTo>
                  <a:lnTo>
                    <a:pt x="1495" y="854"/>
                  </a:lnTo>
                  <a:lnTo>
                    <a:pt x="1501" y="854"/>
                  </a:lnTo>
                  <a:lnTo>
                    <a:pt x="1508" y="852"/>
                  </a:lnTo>
                  <a:lnTo>
                    <a:pt x="1514" y="854"/>
                  </a:lnTo>
                  <a:lnTo>
                    <a:pt x="1521" y="854"/>
                  </a:lnTo>
                </a:path>
              </a:pathLst>
            </a:custGeom>
            <a:noFill/>
            <a:ln w="190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198"/>
            <p:cNvSpPr>
              <a:spLocks noChangeArrowheads="1"/>
            </p:cNvSpPr>
            <p:nvPr/>
          </p:nvSpPr>
          <p:spPr bwMode="auto">
            <a:xfrm>
              <a:off x="1104900" y="994575"/>
              <a:ext cx="7845425" cy="5736425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" name="Line 169"/>
            <p:cNvSpPr>
              <a:spLocks noChangeShapeType="1"/>
            </p:cNvSpPr>
            <p:nvPr/>
          </p:nvSpPr>
          <p:spPr bwMode="auto">
            <a:xfrm flipH="1">
              <a:off x="2168523" y="1092041"/>
              <a:ext cx="26987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Line 162"/>
            <p:cNvSpPr>
              <a:spLocks noChangeShapeType="1"/>
            </p:cNvSpPr>
            <p:nvPr/>
          </p:nvSpPr>
          <p:spPr bwMode="auto">
            <a:xfrm flipH="1" flipV="1">
              <a:off x="2137681" y="4818771"/>
              <a:ext cx="60761" cy="394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Line 162"/>
            <p:cNvSpPr>
              <a:spLocks noChangeShapeType="1"/>
            </p:cNvSpPr>
            <p:nvPr/>
          </p:nvSpPr>
          <p:spPr bwMode="auto">
            <a:xfrm flipH="1" flipV="1">
              <a:off x="2137352" y="2332981"/>
              <a:ext cx="60761" cy="394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" name="Line 162"/>
            <p:cNvSpPr>
              <a:spLocks noChangeShapeType="1"/>
            </p:cNvSpPr>
            <p:nvPr/>
          </p:nvSpPr>
          <p:spPr bwMode="auto">
            <a:xfrm flipH="1" flipV="1">
              <a:off x="2144492" y="1092908"/>
              <a:ext cx="60761" cy="394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54" name="TextBox 1"/>
          <p:cNvSpPr txBox="1"/>
          <p:nvPr/>
        </p:nvSpPr>
        <p:spPr>
          <a:xfrm>
            <a:off x="5594642" y="2807841"/>
            <a:ext cx="1414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Harzianum A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0" y="99583"/>
            <a:ext cx="9143999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S5 Figure: </a:t>
            </a:r>
            <a:r>
              <a:rPr lang="en-US" sz="1100" dirty="0" smtClean="0"/>
              <a:t>Liquid </a:t>
            </a:r>
            <a:r>
              <a:rPr lang="en-US" sz="1100" dirty="0"/>
              <a:t>chromatography-tandem mass spectrometry analysis of the </a:t>
            </a:r>
            <a:r>
              <a:rPr lang="en-US" sz="1100" i="1" dirty="0"/>
              <a:t>T. arundinaceum tri17 </a:t>
            </a:r>
            <a:r>
              <a:rPr lang="en-US" sz="1100" dirty="0"/>
              <a:t>mutant tri17.139 complemented with the </a:t>
            </a:r>
            <a:r>
              <a:rPr lang="en-US" sz="1100" i="1" dirty="0"/>
              <a:t>M. roridum TRI17 </a:t>
            </a:r>
            <a:r>
              <a:rPr lang="en-US" sz="1100" dirty="0"/>
              <a:t>homolog. Results are presented for the wild-type progenitor strain (blue trace) and complementation strains tri17.MrT17.C3 (black trace) and tri17.MrT17.C4 (red trace). The trace for </a:t>
            </a:r>
            <a:r>
              <a:rPr lang="en-US" sz="1100" i="1" dirty="0"/>
              <a:t>tri17 </a:t>
            </a:r>
            <a:r>
              <a:rPr lang="en-US" sz="1100" dirty="0"/>
              <a:t>mutant strain tri17.139 (purple trace) does not rise above the base line. Identity of harzianum A in samples was confirmed by comparison of mass spectra to the spectrum of a purified harzianum A standard, the identity of which was confirmed by </a:t>
            </a:r>
            <a:r>
              <a:rPr lang="en-US" sz="1100" baseline="30000" dirty="0"/>
              <a:t>1</a:t>
            </a:r>
            <a:r>
              <a:rPr lang="en-US" sz="1100" dirty="0"/>
              <a:t>H and </a:t>
            </a:r>
            <a:r>
              <a:rPr lang="en-US" sz="1100" baseline="30000" dirty="0"/>
              <a:t>13</a:t>
            </a:r>
            <a:r>
              <a:rPr lang="en-US" sz="1100" dirty="0"/>
              <a:t>C NMR. Strains were grown in YEPD medium for one week.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1297591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37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4</cp:revision>
  <dcterms:created xsi:type="dcterms:W3CDTF">2017-12-13T18:44:56Z</dcterms:created>
  <dcterms:modified xsi:type="dcterms:W3CDTF">2018-03-01T18:20:01Z</dcterms:modified>
</cp:coreProperties>
</file>